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9" r:id="rId3"/>
    <p:sldId id="260" r:id="rId4"/>
    <p:sldId id="261" r:id="rId5"/>
    <p:sldId id="262" r:id="rId6"/>
    <p:sldId id="265" r:id="rId7"/>
    <p:sldId id="264" r:id="rId8"/>
    <p:sldId id="266" r:id="rId9"/>
    <p:sldId id="267" r:id="rId10"/>
    <p:sldId id="269" r:id="rId11"/>
    <p:sldId id="268" r:id="rId12"/>
    <p:sldId id="270" r:id="rId1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585"/>
    <p:restoredTop sz="94681"/>
  </p:normalViewPr>
  <p:slideViewPr>
    <p:cSldViewPr snapToGrid="0" snapToObjects="1">
      <p:cViewPr varScale="1">
        <p:scale>
          <a:sx n="181" d="100"/>
          <a:sy n="181" d="100"/>
        </p:scale>
        <p:origin x="14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abemasa-imac27/Desktop/New%20PKD1&#35542;&#25991;/PKD1&#35542;&#25991;%20Table&#2080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1 vs WT体重(Sup Fig2'!$D$33</c:f>
              <c:strCache>
                <c:ptCount val="1"/>
                <c:pt idx="0">
                  <c:v>PKD1 F1 (n=5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1 vs WT体重(Sup Fig2'!$J$7:$J$12</c:f>
                <c:numCache>
                  <c:formatCode>General</c:formatCode>
                  <c:ptCount val="6"/>
                  <c:pt idx="0">
                    <c:v>0.1125077775089349</c:v>
                  </c:pt>
                  <c:pt idx="1">
                    <c:v>1.0368220676663875</c:v>
                  </c:pt>
                  <c:pt idx="2">
                    <c:v>3.7349698793966182</c:v>
                  </c:pt>
                  <c:pt idx="3">
                    <c:v>6.4652919500978419</c:v>
                  </c:pt>
                  <c:pt idx="4">
                    <c:v>4.3931765272977596</c:v>
                  </c:pt>
                  <c:pt idx="5">
                    <c:v>6.0991802727907629</c:v>
                  </c:pt>
                </c:numCache>
              </c:numRef>
            </c:plus>
            <c:minus>
              <c:numRef>
                <c:f>'F1 vs WT体重(Sup Fig2'!$J$7:$J$12</c:f>
                <c:numCache>
                  <c:formatCode>General</c:formatCode>
                  <c:ptCount val="6"/>
                  <c:pt idx="0">
                    <c:v>0.1125077775089349</c:v>
                  </c:pt>
                  <c:pt idx="1">
                    <c:v>1.0368220676663875</c:v>
                  </c:pt>
                  <c:pt idx="2">
                    <c:v>3.7349698793966182</c:v>
                  </c:pt>
                  <c:pt idx="3">
                    <c:v>6.4652919500978419</c:v>
                  </c:pt>
                  <c:pt idx="4">
                    <c:v>4.3931765272977596</c:v>
                  </c:pt>
                  <c:pt idx="5">
                    <c:v>6.09918027279076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1 vs WT体重(Sup Fig2'!$C$34:$C$39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F1 vs WT体重(Sup Fig2'!$D$34:$D$39</c:f>
              <c:numCache>
                <c:formatCode>General</c:formatCode>
                <c:ptCount val="6"/>
                <c:pt idx="0">
                  <c:v>1.345</c:v>
                </c:pt>
                <c:pt idx="1">
                  <c:v>7.3</c:v>
                </c:pt>
                <c:pt idx="2">
                  <c:v>16.2</c:v>
                </c:pt>
                <c:pt idx="3">
                  <c:v>39.9</c:v>
                </c:pt>
                <c:pt idx="4">
                  <c:v>54.4</c:v>
                </c:pt>
                <c:pt idx="5">
                  <c:v>62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E5-CA43-B9C7-549205421654}"/>
            </c:ext>
          </c:extLst>
        </c:ser>
        <c:ser>
          <c:idx val="1"/>
          <c:order val="1"/>
          <c:tx>
            <c:strRef>
              <c:f>'F1 vs WT体重(Sup Fig2'!$E$33</c:f>
              <c:strCache>
                <c:ptCount val="1"/>
                <c:pt idx="0">
                  <c:v>WT (n＝5)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1 vs WT体重(Sup Fig2'!$J$19:$J$24</c:f>
                <c:numCache>
                  <c:formatCode>General</c:formatCode>
                  <c:ptCount val="6"/>
                  <c:pt idx="0">
                    <c:v>0.22595729685053315</c:v>
                  </c:pt>
                  <c:pt idx="1">
                    <c:v>1.0253234855400508</c:v>
                  </c:pt>
                  <c:pt idx="2">
                    <c:v>1.6021860066796241</c:v>
                  </c:pt>
                  <c:pt idx="3">
                    <c:v>2.1833460559425739</c:v>
                  </c:pt>
                  <c:pt idx="4">
                    <c:v>3.2912003889158759</c:v>
                  </c:pt>
                  <c:pt idx="5">
                    <c:v>6.4265076052238514</c:v>
                  </c:pt>
                </c:numCache>
              </c:numRef>
            </c:plus>
            <c:minus>
              <c:numRef>
                <c:f>'F1 vs WT体重(Sup Fig2'!$J$19:$J$24</c:f>
                <c:numCache>
                  <c:formatCode>General</c:formatCode>
                  <c:ptCount val="6"/>
                  <c:pt idx="0">
                    <c:v>0.22595729685053315</c:v>
                  </c:pt>
                  <c:pt idx="1">
                    <c:v>1.0253234855400508</c:v>
                  </c:pt>
                  <c:pt idx="2">
                    <c:v>1.6021860066796241</c:v>
                  </c:pt>
                  <c:pt idx="3">
                    <c:v>2.1833460559425739</c:v>
                  </c:pt>
                  <c:pt idx="4">
                    <c:v>3.2912003889158759</c:v>
                  </c:pt>
                  <c:pt idx="5">
                    <c:v>6.42650760522385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1 vs WT体重(Sup Fig2'!$C$34:$C$39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'F1 vs WT体重(Sup Fig2'!$E$34:$E$39</c:f>
              <c:numCache>
                <c:formatCode>General</c:formatCode>
                <c:ptCount val="6"/>
                <c:pt idx="0">
                  <c:v>0.87780000000000002</c:v>
                </c:pt>
                <c:pt idx="1">
                  <c:v>6.6597499999999998</c:v>
                </c:pt>
                <c:pt idx="2">
                  <c:v>20.419999999999998</c:v>
                </c:pt>
                <c:pt idx="3">
                  <c:v>36.220000000000006</c:v>
                </c:pt>
                <c:pt idx="4">
                  <c:v>48.02</c:v>
                </c:pt>
                <c:pt idx="5">
                  <c:v>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8E5-CA43-B9C7-5492054216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17297168"/>
        <c:axId val="1017298848"/>
      </c:lineChart>
      <c:catAx>
        <c:axId val="101729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17298848"/>
        <c:crosses val="autoZero"/>
        <c:auto val="1"/>
        <c:lblAlgn val="ctr"/>
        <c:lblOffset val="100"/>
        <c:noMultiLvlLbl val="0"/>
      </c:catAx>
      <c:valAx>
        <c:axId val="1017298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17297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314605739913905"/>
          <c:y val="6.6203976425752445E-2"/>
          <c:w val="0.26728844757800951"/>
          <c:h val="0.1714868867556647"/>
        </c:manualLayout>
      </c:layout>
      <c:overlay val="0"/>
      <c:spPr>
        <a:solidFill>
          <a:schemeClr val="bg1"/>
        </a:solidFill>
        <a:ln>
          <a:solidFill>
            <a:schemeClr val="tx1">
              <a:lumMod val="65000"/>
              <a:lumOff val="35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58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8404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264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664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55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41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403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084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12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691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380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6B8F7-3299-0343-B4CD-FF416F359400}" type="datetimeFigureOut">
              <a:rPr kumimoji="1" lang="ja-JP" altLang="en-US" smtClean="0"/>
              <a:t>2021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B5C5A-493E-F04A-9441-3F33A585D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16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10" Type="http://schemas.openxmlformats.org/officeDocument/2006/relationships/image" Target="../media/image27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E530AA8B-4563-B343-BFA1-F5E1B76820D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375104" y="653947"/>
            <a:ext cx="1655416" cy="1468075"/>
          </a:xfrm>
          <a:prstGeom prst="rect">
            <a:avLst/>
          </a:prstGeom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FB0AD02D-1DD6-0F4B-B826-AEA94BB270BA}"/>
              </a:ext>
            </a:extLst>
          </p:cNvPr>
          <p:cNvSpPr txBox="1"/>
          <p:nvPr/>
        </p:nvSpPr>
        <p:spPr>
          <a:xfrm>
            <a:off x="1578831" y="4508263"/>
            <a:ext cx="90441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K91</a:t>
            </a:r>
          </a:p>
          <a:p>
            <a:pPr algn="ctr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8 months)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BFFF85B-C657-9A43-A7E4-9EC9B78CAE56}"/>
              </a:ext>
            </a:extLst>
          </p:cNvPr>
          <p:cNvSpPr txBox="1"/>
          <p:nvPr/>
        </p:nvSpPr>
        <p:spPr>
          <a:xfrm>
            <a:off x="1609585" y="2855473"/>
            <a:ext cx="90441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K93</a:t>
            </a:r>
          </a:p>
          <a:p>
            <a:pPr algn="ctr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5 months)</a:t>
            </a: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81047CC3-4D76-B641-8D62-815D16D47FDC}"/>
              </a:ext>
            </a:extLst>
          </p:cNvPr>
          <p:cNvGrpSpPr/>
          <p:nvPr/>
        </p:nvGrpSpPr>
        <p:grpSpPr>
          <a:xfrm>
            <a:off x="1889068" y="655668"/>
            <a:ext cx="1625163" cy="1464882"/>
            <a:chOff x="1564567" y="1254717"/>
            <a:chExt cx="1625163" cy="1464882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8E873819-6AA2-A540-A68F-70ABBEDB1D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64567" y="1254717"/>
              <a:ext cx="1625163" cy="1464882"/>
            </a:xfrm>
            <a:prstGeom prst="rect">
              <a:avLst/>
            </a:prstGeom>
          </p:spPr>
        </p:pic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120141B-3FD8-A940-B455-A636CDF2429C}"/>
                </a:ext>
              </a:extLst>
            </p:cNvPr>
            <p:cNvSpPr txBox="1"/>
            <p:nvPr/>
          </p:nvSpPr>
          <p:spPr>
            <a:xfrm>
              <a:off x="1565374" y="1254717"/>
              <a:ext cx="41870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91</a:t>
              </a: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5EAE16A-7129-2B45-8016-E1C252F6B98B}"/>
              </a:ext>
            </a:extLst>
          </p:cNvPr>
          <p:cNvGrpSpPr/>
          <p:nvPr/>
        </p:nvGrpSpPr>
        <p:grpSpPr>
          <a:xfrm>
            <a:off x="3615869" y="653948"/>
            <a:ext cx="1666785" cy="1464882"/>
            <a:chOff x="3592080" y="1252997"/>
            <a:chExt cx="1666785" cy="1464882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2951C2DF-7FD3-7F4E-AB1D-5BC04D9259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92870" y="1252997"/>
              <a:ext cx="1665995" cy="1464882"/>
            </a:xfrm>
            <a:prstGeom prst="rect">
              <a:avLst/>
            </a:prstGeom>
          </p:spPr>
        </p:pic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F98EEF7-DB71-EA49-AD1B-1AE8C7026083}"/>
                </a:ext>
              </a:extLst>
            </p:cNvPr>
            <p:cNvSpPr txBox="1"/>
            <p:nvPr/>
          </p:nvSpPr>
          <p:spPr>
            <a:xfrm>
              <a:off x="3592080" y="1252997"/>
              <a:ext cx="418704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92</a:t>
              </a:r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6A2494E-B894-2649-9439-E62C0F4073AB}"/>
              </a:ext>
            </a:extLst>
          </p:cNvPr>
          <p:cNvSpPr txBox="1"/>
          <p:nvPr/>
        </p:nvSpPr>
        <p:spPr>
          <a:xfrm>
            <a:off x="5367964" y="653947"/>
            <a:ext cx="418704" cy="246221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K93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91A8BEE-9EC2-8943-998E-6031F71D7400}"/>
              </a:ext>
            </a:extLst>
          </p:cNvPr>
          <p:cNvSpPr txBox="1"/>
          <p:nvPr/>
        </p:nvSpPr>
        <p:spPr>
          <a:xfrm>
            <a:off x="1401332" y="31553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4FF7AE4-07EC-7742-AC79-1FDC6E36ECBE}"/>
              </a:ext>
            </a:extLst>
          </p:cNvPr>
          <p:cNvSpPr txBox="1"/>
          <p:nvPr/>
        </p:nvSpPr>
        <p:spPr>
          <a:xfrm>
            <a:off x="1401332" y="241032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53D9C095-1DE2-704D-AAE3-6AC346F018F6}"/>
              </a:ext>
            </a:extLst>
          </p:cNvPr>
          <p:cNvCxnSpPr>
            <a:cxnSpLocks/>
          </p:cNvCxnSpPr>
          <p:nvPr/>
        </p:nvCxnSpPr>
        <p:spPr>
          <a:xfrm>
            <a:off x="1889068" y="578799"/>
            <a:ext cx="5141452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3F40895-4365-E04C-A95F-957E77DC6083}"/>
              </a:ext>
            </a:extLst>
          </p:cNvPr>
          <p:cNvSpPr txBox="1"/>
          <p:nvPr/>
        </p:nvSpPr>
        <p:spPr>
          <a:xfrm>
            <a:off x="3884329" y="325742"/>
            <a:ext cx="78258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5 months</a:t>
            </a: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A0690664-654B-8441-AA1E-B03D98FCD6DA}"/>
              </a:ext>
            </a:extLst>
          </p:cNvPr>
          <p:cNvGrpSpPr/>
          <p:nvPr/>
        </p:nvGrpSpPr>
        <p:grpSpPr>
          <a:xfrm>
            <a:off x="2561570" y="3988019"/>
            <a:ext cx="2040396" cy="1527109"/>
            <a:chOff x="2803803" y="4627505"/>
            <a:chExt cx="2040396" cy="1527109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D89520EA-9598-E345-82A6-1C522C8C756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03803" y="4627505"/>
              <a:ext cx="2040396" cy="1527109"/>
            </a:xfrm>
            <a:prstGeom prst="rect">
              <a:avLst/>
            </a:prstGeom>
          </p:spPr>
        </p:pic>
        <p:cxnSp>
          <p:nvCxnSpPr>
            <p:cNvPr id="138" name="直線コネクタ 137">
              <a:extLst>
                <a:ext uri="{FF2B5EF4-FFF2-40B4-BE49-F238E27FC236}">
                  <a16:creationId xmlns:a16="http://schemas.microsoft.com/office/drawing/2014/main" id="{4F9C5AB9-255B-CF40-8A47-70E4BE0E796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603951" y="5935808"/>
              <a:ext cx="0" cy="278185"/>
            </a:xfrm>
            <a:prstGeom prst="line">
              <a:avLst/>
            </a:prstGeom>
            <a:ln w="28575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円/楕円 82">
              <a:extLst>
                <a:ext uri="{FF2B5EF4-FFF2-40B4-BE49-F238E27FC236}">
                  <a16:creationId xmlns:a16="http://schemas.microsoft.com/office/drawing/2014/main" id="{82521670-42EE-144B-918F-BA6A09783FC7}"/>
                </a:ext>
              </a:extLst>
            </p:cNvPr>
            <p:cNvSpPr/>
            <p:nvPr/>
          </p:nvSpPr>
          <p:spPr>
            <a:xfrm>
              <a:off x="3566621" y="5070555"/>
              <a:ext cx="628475" cy="628475"/>
            </a:xfrm>
            <a:prstGeom prst="ellipse">
              <a:avLst/>
            </a:prstGeom>
            <a:noFill/>
            <a:ln w="9525">
              <a:solidFill>
                <a:srgbClr val="FFFF00"/>
              </a:solidFill>
              <a:prstDash val="sys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0924114D-DD9F-284E-B052-8BABE7093559}"/>
              </a:ext>
            </a:extLst>
          </p:cNvPr>
          <p:cNvGrpSpPr/>
          <p:nvPr/>
        </p:nvGrpSpPr>
        <p:grpSpPr>
          <a:xfrm>
            <a:off x="2567268" y="2413395"/>
            <a:ext cx="2039311" cy="1523111"/>
            <a:chOff x="2762395" y="2854581"/>
            <a:chExt cx="2241521" cy="1674137"/>
          </a:xfrm>
        </p:grpSpPr>
        <p:pic>
          <p:nvPicPr>
            <p:cNvPr id="133" name="図 132">
              <a:extLst>
                <a:ext uri="{FF2B5EF4-FFF2-40B4-BE49-F238E27FC236}">
                  <a16:creationId xmlns:a16="http://schemas.microsoft.com/office/drawing/2014/main" id="{8DBDDEC2-C647-F448-965D-36E6DB934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62395" y="2854581"/>
              <a:ext cx="2241521" cy="1674137"/>
            </a:xfrm>
            <a:prstGeom prst="rect">
              <a:avLst/>
            </a:prstGeom>
          </p:spPr>
        </p:pic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802C9594-3F54-854B-9EAF-FB48466FAEB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656896" y="4263043"/>
              <a:ext cx="0" cy="367850"/>
            </a:xfrm>
            <a:prstGeom prst="line">
              <a:avLst/>
            </a:prstGeom>
            <a:ln w="28575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889B6B1B-D390-7C45-BA8F-6A495243139C}"/>
              </a:ext>
            </a:extLst>
          </p:cNvPr>
          <p:cNvGrpSpPr/>
          <p:nvPr/>
        </p:nvGrpSpPr>
        <p:grpSpPr>
          <a:xfrm>
            <a:off x="4659847" y="2410328"/>
            <a:ext cx="2046001" cy="1528107"/>
            <a:chOff x="4955756" y="3005781"/>
            <a:chExt cx="2241521" cy="1674136"/>
          </a:xfrm>
        </p:grpSpPr>
        <p:pic>
          <p:nvPicPr>
            <p:cNvPr id="135" name="図 134">
              <a:extLst>
                <a:ext uri="{FF2B5EF4-FFF2-40B4-BE49-F238E27FC236}">
                  <a16:creationId xmlns:a16="http://schemas.microsoft.com/office/drawing/2014/main" id="{EBD664A7-CC04-1B42-AED0-D043413511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55756" y="3005781"/>
              <a:ext cx="2241521" cy="1674136"/>
            </a:xfrm>
            <a:prstGeom prst="rect">
              <a:avLst/>
            </a:prstGeom>
          </p:spPr>
        </p:pic>
        <p:cxnSp>
          <p:nvCxnSpPr>
            <p:cNvPr id="136" name="直線コネクタ 135">
              <a:extLst>
                <a:ext uri="{FF2B5EF4-FFF2-40B4-BE49-F238E27FC236}">
                  <a16:creationId xmlns:a16="http://schemas.microsoft.com/office/drawing/2014/main" id="{FE9B1453-DB2C-0B40-B9D8-C663A5C16A1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913093" y="4412395"/>
              <a:ext cx="0" cy="367850"/>
            </a:xfrm>
            <a:prstGeom prst="line">
              <a:avLst/>
            </a:prstGeom>
            <a:ln w="28575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F409ED95-78DA-784A-B215-72B5A168E642}"/>
              </a:ext>
            </a:extLst>
          </p:cNvPr>
          <p:cNvGrpSpPr/>
          <p:nvPr/>
        </p:nvGrpSpPr>
        <p:grpSpPr>
          <a:xfrm>
            <a:off x="4654149" y="3983824"/>
            <a:ext cx="2046001" cy="1531304"/>
            <a:chOff x="5073810" y="4627505"/>
            <a:chExt cx="2233051" cy="1671299"/>
          </a:xfrm>
        </p:grpSpPr>
        <p:pic>
          <p:nvPicPr>
            <p:cNvPr id="139" name="図 138">
              <a:extLst>
                <a:ext uri="{FF2B5EF4-FFF2-40B4-BE49-F238E27FC236}">
                  <a16:creationId xmlns:a16="http://schemas.microsoft.com/office/drawing/2014/main" id="{B53A4B53-295F-224C-9215-4FB17B78BDD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073810" y="4627505"/>
              <a:ext cx="2233051" cy="1671299"/>
            </a:xfrm>
            <a:prstGeom prst="rect">
              <a:avLst/>
            </a:prstGeom>
          </p:spPr>
        </p:pic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id="{70A10164-B65A-8548-AB75-A8F3EF63BDF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070186" y="6069884"/>
              <a:ext cx="0" cy="288000"/>
            </a:xfrm>
            <a:prstGeom prst="line">
              <a:avLst/>
            </a:prstGeom>
            <a:ln w="28575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二等辺三角形 47">
            <a:extLst>
              <a:ext uri="{FF2B5EF4-FFF2-40B4-BE49-F238E27FC236}">
                <a16:creationId xmlns:a16="http://schemas.microsoft.com/office/drawing/2014/main" id="{1A1D54E6-230C-F043-91FC-C0B2C4ADE832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2557749" y="1153915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二等辺三角形 47">
            <a:extLst>
              <a:ext uri="{FF2B5EF4-FFF2-40B4-BE49-F238E27FC236}">
                <a16:creationId xmlns:a16="http://schemas.microsoft.com/office/drawing/2014/main" id="{1FE3A7C8-CDB4-0440-8D24-9A7A0D44004C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4373866" y="1277101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二等辺三角形 47">
            <a:extLst>
              <a:ext uri="{FF2B5EF4-FFF2-40B4-BE49-F238E27FC236}">
                <a16:creationId xmlns:a16="http://schemas.microsoft.com/office/drawing/2014/main" id="{FA54EFE3-09A8-6643-8F26-914362D3BF14}"/>
              </a:ext>
            </a:extLst>
          </p:cNvPr>
          <p:cNvSpPr>
            <a:spLocks noChangeAspect="1"/>
          </p:cNvSpPr>
          <p:nvPr/>
        </p:nvSpPr>
        <p:spPr>
          <a:xfrm rot="2330977" flipH="1">
            <a:off x="5849457" y="1368270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二等辺三角形 47">
            <a:extLst>
              <a:ext uri="{FF2B5EF4-FFF2-40B4-BE49-F238E27FC236}">
                <a16:creationId xmlns:a16="http://schemas.microsoft.com/office/drawing/2014/main" id="{6ECFADBB-DFC6-A34C-8C3B-FCD83F8D6B4C}"/>
              </a:ext>
            </a:extLst>
          </p:cNvPr>
          <p:cNvSpPr>
            <a:spLocks noChangeAspect="1"/>
          </p:cNvSpPr>
          <p:nvPr/>
        </p:nvSpPr>
        <p:spPr>
          <a:xfrm rot="1343373" flipH="1">
            <a:off x="4111731" y="1266040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DAB73E2-3AAA-5D42-8580-D91282FBF5A8}"/>
              </a:ext>
            </a:extLst>
          </p:cNvPr>
          <p:cNvSpPr/>
          <p:nvPr/>
        </p:nvSpPr>
        <p:spPr>
          <a:xfrm>
            <a:off x="1360258" y="5579066"/>
            <a:ext cx="6257398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</a:pPr>
            <a:r>
              <a:rPr lang="en-US" altLang="ja-JP" sz="105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Fig. S1 Ultrasound diagnostic images and macroscopic photographs of kidneys from </a:t>
            </a:r>
            <a:r>
              <a:rPr lang="en-US" altLang="ja-JP" sz="1050" b="1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050" b="1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05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ounder cloned pigs. 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(</a:t>
            </a:r>
            <a:r>
              <a:rPr lang="en-US" altLang="ja-JP" sz="105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Ultrasound diagnostic images of kidneys from the three </a:t>
            </a:r>
            <a:r>
              <a:rPr lang="en-US" altLang="ja-JP" sz="105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05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loned pigs (K91, K92, and K93) at 5 months of age. Arrowheads indicate representative renal cysts. (</a:t>
            </a:r>
            <a:r>
              <a:rPr lang="en-US" altLang="ja-JP" sz="105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Gross morphology and coronal section of kidneys from two </a:t>
            </a:r>
            <a:r>
              <a:rPr lang="en-US" altLang="ja-JP" sz="105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05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loned pigs at 5 months (K93) and 8 months (K91) of age. The yellow dotted circle indicates multiple renal cysts. The bar represents 3 cm.</a:t>
            </a:r>
            <a:endParaRPr lang="ja-JP" altLang="ja-JP" sz="11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6736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5F9E45D-DCAD-B54F-8981-352320209E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5379267"/>
              </p:ext>
            </p:extLst>
          </p:nvPr>
        </p:nvGraphicFramePr>
        <p:xfrm>
          <a:off x="649751" y="2009324"/>
          <a:ext cx="7886701" cy="2731914"/>
        </p:xfrm>
        <a:graphic>
          <a:graphicData uri="http://schemas.openxmlformats.org/drawingml/2006/table">
            <a:tbl>
              <a:tblPr firstRow="1" firstCol="1" bandRow="1"/>
              <a:tblGrid>
                <a:gridCol w="1286243">
                  <a:extLst>
                    <a:ext uri="{9D8B030D-6E8A-4147-A177-3AD203B41FA5}">
                      <a16:colId xmlns:a16="http://schemas.microsoft.com/office/drawing/2014/main" val="223757829"/>
                    </a:ext>
                  </a:extLst>
                </a:gridCol>
                <a:gridCol w="1286243">
                  <a:extLst>
                    <a:ext uri="{9D8B030D-6E8A-4147-A177-3AD203B41FA5}">
                      <a16:colId xmlns:a16="http://schemas.microsoft.com/office/drawing/2014/main" val="2497035133"/>
                    </a:ext>
                  </a:extLst>
                </a:gridCol>
                <a:gridCol w="1771405">
                  <a:extLst>
                    <a:ext uri="{9D8B030D-6E8A-4147-A177-3AD203B41FA5}">
                      <a16:colId xmlns:a16="http://schemas.microsoft.com/office/drawing/2014/main" val="2559900700"/>
                    </a:ext>
                  </a:extLst>
                </a:gridCol>
                <a:gridCol w="1771405">
                  <a:extLst>
                    <a:ext uri="{9D8B030D-6E8A-4147-A177-3AD203B41FA5}">
                      <a16:colId xmlns:a16="http://schemas.microsoft.com/office/drawing/2014/main" val="3197355993"/>
                    </a:ext>
                  </a:extLst>
                </a:gridCol>
                <a:gridCol w="1771405">
                  <a:extLst>
                    <a:ext uri="{9D8B030D-6E8A-4147-A177-3AD203B41FA5}">
                      <a16:colId xmlns:a16="http://schemas.microsoft.com/office/drawing/2014/main" val="417971050"/>
                    </a:ext>
                  </a:extLst>
                </a:gridCol>
              </a:tblGrid>
              <a:tr h="259594">
                <a:tc gridSpan="5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upplementary Table S2. 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productive performance of </a:t>
                      </a: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200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 heterozygous cloned mutant pigs.</a:t>
                      </a:r>
                      <a:endParaRPr lang="ja-JP" sz="12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650823"/>
                  </a:ext>
                </a:extLst>
              </a:tr>
              <a:tr h="494464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Breeding pair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itter size 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enotype (F1 pigs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190655"/>
                  </a:ext>
                </a:extLst>
              </a:tr>
              <a:tr h="49446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♂ (</a:t>
                      </a:r>
                      <a:r>
                        <a:rPr lang="en-US" sz="1100" b="1" i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 (</a:t>
                      </a: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/+</a:t>
                      </a: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/+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4671593"/>
                  </a:ext>
                </a:extLst>
              </a:tr>
              <a:tr h="494464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K92</a:t>
                      </a:r>
                      <a:b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</a:b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 (Founder clone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237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 (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ple Color Emoji" pitchFamily="2" charset="0"/>
                          <a:ea typeface="Yu Gothic" panose="020B0400000000000000" pitchFamily="34" charset="-128"/>
                          <a:cs typeface="Apple Color Emoji" pitchFamily="2" charset="0"/>
                        </a:rPr>
                        <a:t>♂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Klee Demibold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ple Color Emoji" pitchFamily="2" charset="0"/>
                          <a:ea typeface="Yu Gothic" panose="020B0400000000000000" pitchFamily="34" charset="-128"/>
                          <a:cs typeface="Apple Color Emoji" pitchFamily="2" charset="0"/>
                        </a:rPr>
                        <a:t>♀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 (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ple Color Emoji" pitchFamily="2" charset="0"/>
                          <a:ea typeface="Yu Gothic" panose="020B0400000000000000" pitchFamily="34" charset="-128"/>
                          <a:cs typeface="Apple Color Emoji" pitchFamily="2" charset="0"/>
                        </a:rPr>
                        <a:t>♂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Klee Demibold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ple Color Emoji" pitchFamily="2" charset="0"/>
                          <a:ea typeface="Yu Gothic" panose="020B0400000000000000" pitchFamily="34" charset="-128"/>
                          <a:cs typeface="Apple Color Emoji" pitchFamily="2" charset="0"/>
                        </a:rPr>
                        <a:t>♀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164153"/>
                  </a:ext>
                </a:extLst>
              </a:tr>
              <a:tr h="494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239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 (♂3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ＭＳ 明朝" panose="02020609040205080304" pitchFamily="49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2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 (♂2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1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9645153"/>
                  </a:ext>
                </a:extLst>
              </a:tr>
              <a:tr h="494464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otal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7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0 (♂6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ＭＳ 明朝" panose="02020609040205080304" pitchFamily="49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4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7 (♂4</a:t>
                      </a: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ＭＳ 明朝" panose="02020609040205080304" pitchFamily="49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3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190" marR="6119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16868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35875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06FE753-393C-D740-9254-FFE5232846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9997171"/>
              </p:ext>
            </p:extLst>
          </p:nvPr>
        </p:nvGraphicFramePr>
        <p:xfrm>
          <a:off x="492369" y="1989169"/>
          <a:ext cx="8269166" cy="3025445"/>
        </p:xfrm>
        <a:graphic>
          <a:graphicData uri="http://schemas.openxmlformats.org/drawingml/2006/table">
            <a:tbl>
              <a:tblPr firstRow="1" firstCol="1" bandRow="1"/>
              <a:tblGrid>
                <a:gridCol w="1269343">
                  <a:extLst>
                    <a:ext uri="{9D8B030D-6E8A-4147-A177-3AD203B41FA5}">
                      <a16:colId xmlns:a16="http://schemas.microsoft.com/office/drawing/2014/main" val="1899089558"/>
                    </a:ext>
                  </a:extLst>
                </a:gridCol>
                <a:gridCol w="1269343">
                  <a:extLst>
                    <a:ext uri="{9D8B030D-6E8A-4147-A177-3AD203B41FA5}">
                      <a16:colId xmlns:a16="http://schemas.microsoft.com/office/drawing/2014/main" val="4051585172"/>
                    </a:ext>
                  </a:extLst>
                </a:gridCol>
                <a:gridCol w="1432620">
                  <a:extLst>
                    <a:ext uri="{9D8B030D-6E8A-4147-A177-3AD203B41FA5}">
                      <a16:colId xmlns:a16="http://schemas.microsoft.com/office/drawing/2014/main" val="3194200343"/>
                    </a:ext>
                  </a:extLst>
                </a:gridCol>
                <a:gridCol w="1432620">
                  <a:extLst>
                    <a:ext uri="{9D8B030D-6E8A-4147-A177-3AD203B41FA5}">
                      <a16:colId xmlns:a16="http://schemas.microsoft.com/office/drawing/2014/main" val="245037531"/>
                    </a:ext>
                  </a:extLst>
                </a:gridCol>
                <a:gridCol w="1432620">
                  <a:extLst>
                    <a:ext uri="{9D8B030D-6E8A-4147-A177-3AD203B41FA5}">
                      <a16:colId xmlns:a16="http://schemas.microsoft.com/office/drawing/2014/main" val="3440207918"/>
                    </a:ext>
                  </a:extLst>
                </a:gridCol>
                <a:gridCol w="1432620">
                  <a:extLst>
                    <a:ext uri="{9D8B030D-6E8A-4147-A177-3AD203B41FA5}">
                      <a16:colId xmlns:a16="http://schemas.microsoft.com/office/drawing/2014/main" val="2197339459"/>
                    </a:ext>
                  </a:extLst>
                </a:gridCol>
              </a:tblGrid>
              <a:tr h="231962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upplementary Table S3. 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roduction of homozygous </a:t>
                      </a: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KO progeny by mating of </a:t>
                      </a: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200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 F1 pigs.</a:t>
                      </a:r>
                      <a:endParaRPr lang="ja-JP" sz="12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1208305"/>
                  </a:ext>
                </a:extLst>
              </a:tr>
              <a:tr h="441832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Breeding pair (F1 pigs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itter size 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enotypes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1506509"/>
                  </a:ext>
                </a:extLst>
              </a:tr>
              <a:tr h="24411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♂ (</a:t>
                      </a:r>
                      <a:r>
                        <a:rPr lang="en-US" sz="1100" b="1" i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♀ (</a:t>
                      </a: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/+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+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/</a:t>
                      </a:r>
                      <a:r>
                        <a:rPr lang="en-US" sz="1100" b="1" i="1" kern="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sG</a:t>
                      </a:r>
                      <a:endParaRPr lang="ja-JP" sz="11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657169"/>
                  </a:ext>
                </a:extLst>
              </a:tr>
              <a:tr h="31811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(Heterozygous KO)</a:t>
                      </a:r>
                      <a:endParaRPr lang="ja-JP" sz="10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(Heterozygous KO)</a:t>
                      </a:r>
                      <a:endParaRPr lang="ja-JP" sz="10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(WT)</a:t>
                      </a:r>
                      <a:endParaRPr lang="ja-JP" sz="10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(Heterozygous KO)</a:t>
                      </a:r>
                      <a:endParaRPr lang="ja-JP" sz="10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(Homozygous KO)</a:t>
                      </a:r>
                      <a:endParaRPr lang="ja-JP" sz="1000" b="1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85227"/>
                  </a:ext>
                </a:extLst>
              </a:tr>
              <a:tr h="44183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279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273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9919655"/>
                  </a:ext>
                </a:extLst>
              </a:tr>
              <a:tr h="441832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280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322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7767951"/>
                  </a:ext>
                </a:extLst>
              </a:tr>
              <a:tr h="44183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W273*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6 (E39)**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0184206"/>
                  </a:ext>
                </a:extLst>
              </a:tr>
              <a:tr h="231962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* Second pregnancy.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406598"/>
                  </a:ext>
                </a:extLst>
              </a:tr>
              <a:tr h="231962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** 39-days-old fetuses. 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54677" marR="54677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60591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6448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A60A83D2-06AD-794C-98DF-4156ED8DD3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1108840"/>
              </p:ext>
            </p:extLst>
          </p:nvPr>
        </p:nvGraphicFramePr>
        <p:xfrm>
          <a:off x="438736" y="558340"/>
          <a:ext cx="8276199" cy="5673649"/>
        </p:xfrm>
        <a:graphic>
          <a:graphicData uri="http://schemas.openxmlformats.org/drawingml/2006/table">
            <a:tbl>
              <a:tblPr firstRow="1" firstCol="1" bandRow="1"/>
              <a:tblGrid>
                <a:gridCol w="876593">
                  <a:extLst>
                    <a:ext uri="{9D8B030D-6E8A-4147-A177-3AD203B41FA5}">
                      <a16:colId xmlns:a16="http://schemas.microsoft.com/office/drawing/2014/main" val="3847812783"/>
                    </a:ext>
                  </a:extLst>
                </a:gridCol>
                <a:gridCol w="879231">
                  <a:extLst>
                    <a:ext uri="{9D8B030D-6E8A-4147-A177-3AD203B41FA5}">
                      <a16:colId xmlns:a16="http://schemas.microsoft.com/office/drawing/2014/main" val="3896890010"/>
                    </a:ext>
                  </a:extLst>
                </a:gridCol>
                <a:gridCol w="1132449">
                  <a:extLst>
                    <a:ext uri="{9D8B030D-6E8A-4147-A177-3AD203B41FA5}">
                      <a16:colId xmlns:a16="http://schemas.microsoft.com/office/drawing/2014/main" val="2469605076"/>
                    </a:ext>
                  </a:extLst>
                </a:gridCol>
                <a:gridCol w="1139255">
                  <a:extLst>
                    <a:ext uri="{9D8B030D-6E8A-4147-A177-3AD203B41FA5}">
                      <a16:colId xmlns:a16="http://schemas.microsoft.com/office/drawing/2014/main" val="2275152782"/>
                    </a:ext>
                  </a:extLst>
                </a:gridCol>
                <a:gridCol w="1502745">
                  <a:extLst>
                    <a:ext uri="{9D8B030D-6E8A-4147-A177-3AD203B41FA5}">
                      <a16:colId xmlns:a16="http://schemas.microsoft.com/office/drawing/2014/main" val="2928604576"/>
                    </a:ext>
                  </a:extLst>
                </a:gridCol>
                <a:gridCol w="2745926">
                  <a:extLst>
                    <a:ext uri="{9D8B030D-6E8A-4147-A177-3AD203B41FA5}">
                      <a16:colId xmlns:a16="http://schemas.microsoft.com/office/drawing/2014/main" val="1269335122"/>
                    </a:ext>
                  </a:extLst>
                </a:gridCol>
              </a:tblGrid>
              <a:tr h="310188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upplementary Table S4. 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ummary of </a:t>
                      </a: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heterozygous knockout pigs generated in this study.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6720902"/>
                  </a:ext>
                </a:extLst>
              </a:tr>
              <a:tr h="5739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Generation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ethod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. of  </a:t>
                      </a:r>
                      <a:r>
                        <a:rPr lang="en-US" sz="1100" b="1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b="1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sG/+</a:t>
                      </a: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pig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ig code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Age sacrificed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reeding pair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2877782"/>
                  </a:ext>
                </a:extLst>
              </a:tr>
              <a:tr h="212451"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ounder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(Clone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CNT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1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8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e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774876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2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6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9366016"/>
                  </a:ext>
                </a:extLst>
              </a:tr>
              <a:tr h="23843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3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5217832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4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254974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.51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tillborn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6961122"/>
                  </a:ext>
                </a:extLst>
              </a:tr>
              <a:tr h="218146">
                <a:tc row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1 progeny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ating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79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4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2 (Founder, ♂) x M237 (WT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3247517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80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3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1794478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82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7842906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73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3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6057621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322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4 month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5908699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A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 week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92 (Founder, ♂) x W239 (WT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981924"/>
                  </a:ext>
                </a:extLst>
              </a:tr>
              <a:tr h="212451">
                <a:tc rowSpan="9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2 progeny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9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ating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1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 days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79 (F1, ♂) x #1730 (WT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298046"/>
                  </a:ext>
                </a:extLst>
              </a:tr>
              <a:tr h="26597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2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7362298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3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02389"/>
                  </a:ext>
                </a:extLst>
              </a:tr>
              <a:tr h="2427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4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0890033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6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8777897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#1730-9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7877096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A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fant*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79 (F1, ♂) x W273 (F1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1358328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9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A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fant*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80 (F1, ♂) x W322 (F1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781815"/>
                  </a:ext>
                </a:extLst>
              </a:tr>
              <a:tr h="21245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 (Fetuses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A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Embryonic day 39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W280 (F1, ♂) x W273 (F1, ♀)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536315"/>
                  </a:ext>
                </a:extLst>
              </a:tr>
              <a:tr h="212451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A, Not assigned.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2551121"/>
                  </a:ext>
                </a:extLst>
              </a:tr>
              <a:tr h="212451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* Sacrificed before weaning for identifying </a:t>
                      </a:r>
                      <a:r>
                        <a:rPr lang="en-US" sz="11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sG/</a:t>
                      </a:r>
                      <a:r>
                        <a:rPr lang="en-US" sz="1100" i="1" kern="0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sG</a:t>
                      </a:r>
                      <a:r>
                        <a:rPr lang="en-US" sz="1100" i="1" kern="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individuals.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56615" marR="5661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83183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8505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06EC814-2FE3-E640-B0EC-4F5B2178F922}"/>
              </a:ext>
            </a:extLst>
          </p:cNvPr>
          <p:cNvSpPr txBox="1"/>
          <p:nvPr/>
        </p:nvSpPr>
        <p:spPr>
          <a:xfrm rot="16200000">
            <a:off x="1202246" y="2723837"/>
            <a:ext cx="1857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ody weight (kg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C4A5345-AC8D-5043-A197-700764A5498A}"/>
              </a:ext>
            </a:extLst>
          </p:cNvPr>
          <p:cNvSpPr txBox="1"/>
          <p:nvPr/>
        </p:nvSpPr>
        <p:spPr>
          <a:xfrm>
            <a:off x="3832524" y="4718880"/>
            <a:ext cx="1562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ge (month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D0E7FCDD-97C0-554A-A835-728BA33802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4954393"/>
              </p:ext>
            </p:extLst>
          </p:nvPr>
        </p:nvGraphicFramePr>
        <p:xfrm>
          <a:off x="2348549" y="1498646"/>
          <a:ext cx="4757946" cy="36089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84E3886-8E1F-2042-BFE6-2213FA715A38}"/>
              </a:ext>
            </a:extLst>
          </p:cNvPr>
          <p:cNvSpPr/>
          <p:nvPr/>
        </p:nvSpPr>
        <p:spPr>
          <a:xfrm>
            <a:off x="2131211" y="5386534"/>
            <a:ext cx="4975284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Supplementary Fig. S2 Growth performance of </a:t>
            </a:r>
            <a:r>
              <a:rPr lang="en-US" altLang="ja-JP" sz="1100" b="1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b="1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heterozygous F1 mutant pigs.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1 pigs exhibited normal growth performance compared with that of WT pigs.</a:t>
            </a:r>
            <a:r>
              <a:rPr lang="ja-JP" altLang="ja-JP" sz="1100"/>
              <a:t> </a:t>
            </a:r>
            <a:endParaRPr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2755042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D9F622E-DFE6-B443-B299-F8AA1E3F60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2012" y="3367818"/>
            <a:ext cx="2317411" cy="2076044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63004DEE-16F5-7949-967D-72BF7628D5A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87062" y="3367818"/>
            <a:ext cx="2282511" cy="207604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542B535E-1F16-EE49-9ED4-D7999BF98D4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72012" y="1208924"/>
            <a:ext cx="2317411" cy="2074028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71B456C6-46DF-1740-84F5-FF81CF955CB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87063" y="1208924"/>
            <a:ext cx="2282510" cy="2077891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5454D7E-2035-984B-9ED5-59EDE1A47762}"/>
              </a:ext>
            </a:extLst>
          </p:cNvPr>
          <p:cNvSpPr txBox="1"/>
          <p:nvPr/>
        </p:nvSpPr>
        <p:spPr>
          <a:xfrm>
            <a:off x="2059881" y="1208924"/>
            <a:ext cx="833964" cy="2616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srgbClr val="000000"/>
                </a:solidFill>
                <a:latin typeface="Arial"/>
                <a:cs typeface="Arial"/>
              </a:rPr>
              <a:t>W279 (M)</a:t>
            </a:r>
            <a:endParaRPr kumimoji="1" lang="ja-JP" altLang="en-US" sz="11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534E542-C007-4740-B4C6-E9A1145B87EF}"/>
              </a:ext>
            </a:extLst>
          </p:cNvPr>
          <p:cNvSpPr txBox="1"/>
          <p:nvPr/>
        </p:nvSpPr>
        <p:spPr>
          <a:xfrm>
            <a:off x="2053529" y="3367818"/>
            <a:ext cx="84031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/>
                <a:cs typeface="Arial"/>
              </a:rPr>
              <a:t>W273 (F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3D4EC32-5A65-7E40-855A-BCB5F1BA51FD}"/>
              </a:ext>
            </a:extLst>
          </p:cNvPr>
          <p:cNvSpPr txBox="1"/>
          <p:nvPr/>
        </p:nvSpPr>
        <p:spPr>
          <a:xfrm>
            <a:off x="4575069" y="3367818"/>
            <a:ext cx="833959" cy="2616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srgbClr val="000000"/>
                </a:solidFill>
                <a:latin typeface="Arial"/>
                <a:cs typeface="Arial"/>
              </a:rPr>
              <a:t>W322 (F)</a:t>
            </a:r>
            <a:endParaRPr kumimoji="1" lang="ja-JP" altLang="en-US" sz="11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D3FC31E-ED6E-2A42-A5D7-9A61070725E3}"/>
              </a:ext>
            </a:extLst>
          </p:cNvPr>
          <p:cNvSpPr txBox="1"/>
          <p:nvPr/>
        </p:nvSpPr>
        <p:spPr>
          <a:xfrm>
            <a:off x="4575070" y="1208923"/>
            <a:ext cx="833958" cy="2616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solidFill>
                  <a:srgbClr val="000000"/>
                </a:solidFill>
                <a:latin typeface="Arial"/>
                <a:cs typeface="Arial"/>
              </a:rPr>
              <a:t>W280 (M)</a:t>
            </a:r>
            <a:endParaRPr kumimoji="1" lang="ja-JP" altLang="en-US" sz="11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" name="二等辺三角形 47">
            <a:extLst>
              <a:ext uri="{FF2B5EF4-FFF2-40B4-BE49-F238E27FC236}">
                <a16:creationId xmlns:a16="http://schemas.microsoft.com/office/drawing/2014/main" id="{3A5F45EE-701E-BE46-825B-3FBDD9165601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3329679" y="2477524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二等辺三角形 47">
            <a:extLst>
              <a:ext uri="{FF2B5EF4-FFF2-40B4-BE49-F238E27FC236}">
                <a16:creationId xmlns:a16="http://schemas.microsoft.com/office/drawing/2014/main" id="{71761414-8F48-0B49-93F1-92BF1476E620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3100355" y="4544283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二等辺三角形 47">
            <a:extLst>
              <a:ext uri="{FF2B5EF4-FFF2-40B4-BE49-F238E27FC236}">
                <a16:creationId xmlns:a16="http://schemas.microsoft.com/office/drawing/2014/main" id="{A184864D-7985-5A47-B73C-D8333325814E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2824966" y="4744809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二等辺三角形 47">
            <a:extLst>
              <a:ext uri="{FF2B5EF4-FFF2-40B4-BE49-F238E27FC236}">
                <a16:creationId xmlns:a16="http://schemas.microsoft.com/office/drawing/2014/main" id="{3EC3AD4F-6947-9841-8D61-177365F0C54A}"/>
              </a:ext>
            </a:extLst>
          </p:cNvPr>
          <p:cNvSpPr>
            <a:spLocks noChangeAspect="1"/>
          </p:cNvSpPr>
          <p:nvPr/>
        </p:nvSpPr>
        <p:spPr>
          <a:xfrm rot="19800000" flipH="1">
            <a:off x="5877247" y="2250343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二等辺三角形 47">
            <a:extLst>
              <a:ext uri="{FF2B5EF4-FFF2-40B4-BE49-F238E27FC236}">
                <a16:creationId xmlns:a16="http://schemas.microsoft.com/office/drawing/2014/main" id="{9504B0ED-E7B3-8A4A-BB01-9DB26CE6A417}"/>
              </a:ext>
            </a:extLst>
          </p:cNvPr>
          <p:cNvSpPr>
            <a:spLocks noChangeAspect="1"/>
          </p:cNvSpPr>
          <p:nvPr/>
        </p:nvSpPr>
        <p:spPr>
          <a:xfrm rot="19354925" flipH="1">
            <a:off x="6090928" y="4215475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二等辺三角形 47">
            <a:extLst>
              <a:ext uri="{FF2B5EF4-FFF2-40B4-BE49-F238E27FC236}">
                <a16:creationId xmlns:a16="http://schemas.microsoft.com/office/drawing/2014/main" id="{B74967CE-6245-9F46-855D-AC7E56040E50}"/>
              </a:ext>
            </a:extLst>
          </p:cNvPr>
          <p:cNvSpPr>
            <a:spLocks noChangeAspect="1"/>
          </p:cNvSpPr>
          <p:nvPr/>
        </p:nvSpPr>
        <p:spPr>
          <a:xfrm rot="743407" flipH="1">
            <a:off x="5510953" y="2389817"/>
            <a:ext cx="45719" cy="104884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2AAB681-E807-6148-B3A5-9CD7E97BE4E3}"/>
              </a:ext>
            </a:extLst>
          </p:cNvPr>
          <p:cNvSpPr/>
          <p:nvPr/>
        </p:nvSpPr>
        <p:spPr>
          <a:xfrm>
            <a:off x="1922995" y="5718381"/>
            <a:ext cx="507568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Supplementary Fig. S3 Ultrasound diagnostic images of kidneys in the F1 progeny at 5 months of age.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Ultrasound diagnostic images of kidneys in four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1 progeny. Renal cyst formation was detected in all F1 pigs analyzed. M, male; F, female. Arrowheads indicate representative renal cysts.</a:t>
            </a:r>
            <a:r>
              <a:rPr lang="ja-JP" altLang="ja-JP" sz="1100"/>
              <a:t> </a:t>
            </a:r>
            <a:endParaRPr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40555586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7575B19C-AFB5-304C-B41E-C68B21C702DD}"/>
              </a:ext>
            </a:extLst>
          </p:cNvPr>
          <p:cNvGrpSpPr/>
          <p:nvPr/>
        </p:nvGrpSpPr>
        <p:grpSpPr>
          <a:xfrm>
            <a:off x="1410444" y="1103869"/>
            <a:ext cx="2021753" cy="1516315"/>
            <a:chOff x="134808" y="956453"/>
            <a:chExt cx="2760370" cy="2070278"/>
          </a:xfrm>
        </p:grpSpPr>
        <p:pic>
          <p:nvPicPr>
            <p:cNvPr id="66" name="図 65">
              <a:extLst>
                <a:ext uri="{FF2B5EF4-FFF2-40B4-BE49-F238E27FC236}">
                  <a16:creationId xmlns:a16="http://schemas.microsoft.com/office/drawing/2014/main" id="{1FE5B452-E831-AB48-AB52-A7ED23DAFB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alphaModFix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4808" y="956453"/>
              <a:ext cx="2760370" cy="2070278"/>
            </a:xfrm>
            <a:prstGeom prst="rect">
              <a:avLst/>
            </a:prstGeom>
          </p:spPr>
        </p:pic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DF69006D-9625-3342-92F3-3855B6A63597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2621188" y="2788992"/>
              <a:ext cx="1" cy="308283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622B2323-3D4C-5C48-BF0B-86287C58B007}"/>
              </a:ext>
            </a:extLst>
          </p:cNvPr>
          <p:cNvGrpSpPr/>
          <p:nvPr/>
        </p:nvGrpSpPr>
        <p:grpSpPr>
          <a:xfrm>
            <a:off x="3515383" y="1103869"/>
            <a:ext cx="2017342" cy="1513007"/>
            <a:chOff x="2973147" y="1658095"/>
            <a:chExt cx="2897576" cy="2173182"/>
          </a:xfrm>
        </p:grpSpPr>
        <p:pic>
          <p:nvPicPr>
            <p:cNvPr id="62" name="図 61">
              <a:extLst>
                <a:ext uri="{FF2B5EF4-FFF2-40B4-BE49-F238E27FC236}">
                  <a16:creationId xmlns:a16="http://schemas.microsoft.com/office/drawing/2014/main" id="{A94D24FE-B7A0-6D41-9980-E2749C53EF4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alphaModFix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73147" y="1658095"/>
              <a:ext cx="2897576" cy="2173182"/>
            </a:xfrm>
            <a:prstGeom prst="rect">
              <a:avLst/>
            </a:prstGeom>
          </p:spPr>
        </p:pic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8AFE2374-1B7C-744F-8007-F8342504CE6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5038" y="3524557"/>
              <a:ext cx="0" cy="360638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AF7FECEE-D4B2-0C44-A297-EB93CC502EDD}"/>
              </a:ext>
            </a:extLst>
          </p:cNvPr>
          <p:cNvGrpSpPr/>
          <p:nvPr/>
        </p:nvGrpSpPr>
        <p:grpSpPr>
          <a:xfrm>
            <a:off x="5615911" y="1118445"/>
            <a:ext cx="2008499" cy="1506375"/>
            <a:chOff x="4656545" y="1200630"/>
            <a:chExt cx="2585026" cy="1938770"/>
          </a:xfrm>
        </p:grpSpPr>
        <p:pic>
          <p:nvPicPr>
            <p:cNvPr id="64" name="図 63">
              <a:extLst>
                <a:ext uri="{FF2B5EF4-FFF2-40B4-BE49-F238E27FC236}">
                  <a16:creationId xmlns:a16="http://schemas.microsoft.com/office/drawing/2014/main" id="{DD2DEC10-E65F-D14B-89D0-9BB0C3C9139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alphaModFix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56545" y="1200630"/>
              <a:ext cx="2585026" cy="1938770"/>
            </a:xfrm>
            <a:prstGeom prst="rect">
              <a:avLst/>
            </a:prstGeom>
          </p:spPr>
        </p:pic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7540B68A-F9B7-E345-A7E7-16A4ECDBFE8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908032" y="2848040"/>
              <a:ext cx="0" cy="368934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7A4088BB-9D2F-1F47-88F7-0289AA1B7A7F}"/>
              </a:ext>
            </a:extLst>
          </p:cNvPr>
          <p:cNvGrpSpPr/>
          <p:nvPr/>
        </p:nvGrpSpPr>
        <p:grpSpPr>
          <a:xfrm>
            <a:off x="1410445" y="2669714"/>
            <a:ext cx="3076251" cy="2307189"/>
            <a:chOff x="1321500" y="2552257"/>
            <a:chExt cx="3030614" cy="2272961"/>
          </a:xfrm>
        </p:grpSpPr>
        <p:pic>
          <p:nvPicPr>
            <p:cNvPr id="68" name="図 67">
              <a:extLst>
                <a:ext uri="{FF2B5EF4-FFF2-40B4-BE49-F238E27FC236}">
                  <a16:creationId xmlns:a16="http://schemas.microsoft.com/office/drawing/2014/main" id="{872A00BA-0BFB-3146-9426-A1D9F9FCA1B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21500" y="2552257"/>
              <a:ext cx="3030614" cy="2272961"/>
            </a:xfrm>
            <a:prstGeom prst="rect">
              <a:avLst/>
            </a:prstGeom>
          </p:spPr>
        </p:pic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38C0EF75-5AC4-A642-A523-BE0C01853A9E}"/>
                </a:ext>
              </a:extLst>
            </p:cNvPr>
            <p:cNvCxnSpPr>
              <a:cxnSpLocks/>
            </p:cNvCxnSpPr>
            <p:nvPr/>
          </p:nvCxnSpPr>
          <p:spPr>
            <a:xfrm>
              <a:off x="1432623" y="4702332"/>
              <a:ext cx="414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181BCD75-C02C-4641-A028-9AFF99874F06}"/>
                </a:ext>
              </a:extLst>
            </p:cNvPr>
            <p:cNvSpPr txBox="1"/>
            <p:nvPr/>
          </p:nvSpPr>
          <p:spPr>
            <a:xfrm>
              <a:off x="1945894" y="3487102"/>
              <a:ext cx="251412" cy="3032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5EC554D-7C1B-FB4E-AD6D-75703FF7CE66}"/>
                </a:ext>
              </a:extLst>
            </p:cNvPr>
            <p:cNvSpPr txBox="1"/>
            <p:nvPr/>
          </p:nvSpPr>
          <p:spPr>
            <a:xfrm>
              <a:off x="3393466" y="2716498"/>
              <a:ext cx="251412" cy="3032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284DDB4-E29A-ED48-9100-BF3756CBAF83}"/>
              </a:ext>
            </a:extLst>
          </p:cNvPr>
          <p:cNvSpPr txBox="1"/>
          <p:nvPr/>
        </p:nvSpPr>
        <p:spPr>
          <a:xfrm>
            <a:off x="1356828" y="1095187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DA24BB0-10EC-104E-BB97-D3409DDD67ED}"/>
              </a:ext>
            </a:extLst>
          </p:cNvPr>
          <p:cNvSpPr txBox="1"/>
          <p:nvPr/>
        </p:nvSpPr>
        <p:spPr>
          <a:xfrm>
            <a:off x="3446298" y="1095187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5EF3BD1-326D-4C47-87EE-B9C5E57BED33}"/>
              </a:ext>
            </a:extLst>
          </p:cNvPr>
          <p:cNvSpPr txBox="1"/>
          <p:nvPr/>
        </p:nvSpPr>
        <p:spPr>
          <a:xfrm>
            <a:off x="5552600" y="1095187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C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3678A28-D9B4-3C40-BEFF-E83F9BC3A105}"/>
              </a:ext>
            </a:extLst>
          </p:cNvPr>
          <p:cNvSpPr txBox="1"/>
          <p:nvPr/>
        </p:nvSpPr>
        <p:spPr>
          <a:xfrm>
            <a:off x="1373660" y="2669812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D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3E9CA962-C449-024A-B988-383CD4573B0D}"/>
              </a:ext>
            </a:extLst>
          </p:cNvPr>
          <p:cNvGrpSpPr/>
          <p:nvPr/>
        </p:nvGrpSpPr>
        <p:grpSpPr>
          <a:xfrm>
            <a:off x="4548157" y="2669714"/>
            <a:ext cx="3076253" cy="2307189"/>
            <a:chOff x="4461071" y="2523015"/>
            <a:chExt cx="3076253" cy="2307189"/>
          </a:xfrm>
        </p:grpSpPr>
        <p:pic>
          <p:nvPicPr>
            <p:cNvPr id="71" name="図 70">
              <a:extLst>
                <a:ext uri="{FF2B5EF4-FFF2-40B4-BE49-F238E27FC236}">
                  <a16:creationId xmlns:a16="http://schemas.microsoft.com/office/drawing/2014/main" id="{64FB2BF0-FDC6-994F-A160-2DA5841670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1071" y="2523015"/>
              <a:ext cx="3076253" cy="2307189"/>
            </a:xfrm>
            <a:prstGeom prst="rect">
              <a:avLst/>
            </a:prstGeom>
          </p:spPr>
        </p:pic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55A21DD0-3867-7D4B-A4B9-4EF23252A372}"/>
                </a:ext>
              </a:extLst>
            </p:cNvPr>
            <p:cNvCxnSpPr>
              <a:cxnSpLocks/>
            </p:cNvCxnSpPr>
            <p:nvPr/>
          </p:nvCxnSpPr>
          <p:spPr>
            <a:xfrm>
              <a:off x="4575595" y="4705467"/>
              <a:ext cx="42023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B643B910-7952-8D46-8EC5-77B2771D2CC1}"/>
                </a:ext>
              </a:extLst>
            </p:cNvPr>
            <p:cNvSpPr txBox="1"/>
            <p:nvPr/>
          </p:nvSpPr>
          <p:spPr>
            <a:xfrm>
              <a:off x="6398672" y="260205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ECB1CD30-8A8A-934C-BC47-05D5C28E5B4A}"/>
                </a:ext>
              </a:extLst>
            </p:cNvPr>
            <p:cNvSpPr txBox="1"/>
            <p:nvPr/>
          </p:nvSpPr>
          <p:spPr>
            <a:xfrm>
              <a:off x="5260021" y="3471938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B9F55DF-1292-874F-A99E-1C381EA5062D}"/>
              </a:ext>
            </a:extLst>
          </p:cNvPr>
          <p:cNvSpPr txBox="1"/>
          <p:nvPr/>
        </p:nvSpPr>
        <p:spPr>
          <a:xfrm>
            <a:off x="4520047" y="2669812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E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C3D18FD-D01D-E841-98FE-F1E4276BE2AB}"/>
              </a:ext>
            </a:extLst>
          </p:cNvPr>
          <p:cNvSpPr/>
          <p:nvPr/>
        </p:nvSpPr>
        <p:spPr>
          <a:xfrm>
            <a:off x="1333736" y="5469128"/>
            <a:ext cx="6290674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</a:pP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Fig. S4 Cyst formation of a </a:t>
            </a:r>
            <a:r>
              <a:rPr lang="en-US" altLang="ja-JP" sz="1100" b="1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b="1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</a:t>
            </a: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F1 pig at 53 months of age.</a:t>
            </a:r>
            <a:endParaRPr lang="ja-JP" altLang="ja-JP" sz="11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  <a:p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The gross morphology of bilateral kidneys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A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and coronal sections of the kidneys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B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; left kidney, 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C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; right kidney) in a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 F1 pig (W280).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Yellow arrowhead indicates renal cysts.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The bar is 3 cm.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D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Sections of Masson’s trichrome staining and immunostaining using PKD1 antibody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E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in the</a:t>
            </a:r>
            <a:r>
              <a:rPr lang="en-US" altLang="ja-JP" sz="1100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 F1 pig. Asterisks indicate renal cysts. The bar is 100 µm.</a:t>
            </a:r>
            <a:r>
              <a:rPr lang="ja-JP" altLang="ja-JP" sz="1100"/>
              <a:t> </a:t>
            </a:r>
            <a:endParaRPr lang="ja-JP" altLang="en-US" sz="1100"/>
          </a:p>
        </p:txBody>
      </p:sp>
      <p:sp>
        <p:nvSpPr>
          <p:cNvPr id="27" name="二等辺三角形 26">
            <a:extLst>
              <a:ext uri="{FF2B5EF4-FFF2-40B4-BE49-F238E27FC236}">
                <a16:creationId xmlns:a16="http://schemas.microsoft.com/office/drawing/2014/main" id="{9D9F1A03-0D7E-5E46-BC40-B54D3FA2716D}"/>
              </a:ext>
            </a:extLst>
          </p:cNvPr>
          <p:cNvSpPr>
            <a:spLocks noChangeAspect="1"/>
          </p:cNvSpPr>
          <p:nvPr/>
        </p:nvSpPr>
        <p:spPr>
          <a:xfrm rot="12310471">
            <a:off x="2020213" y="1267728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二等辺三角形 26">
            <a:extLst>
              <a:ext uri="{FF2B5EF4-FFF2-40B4-BE49-F238E27FC236}">
                <a16:creationId xmlns:a16="http://schemas.microsoft.com/office/drawing/2014/main" id="{39E62B99-9765-E04C-BD8F-887333BD0A97}"/>
              </a:ext>
            </a:extLst>
          </p:cNvPr>
          <p:cNvSpPr>
            <a:spLocks noChangeAspect="1"/>
          </p:cNvSpPr>
          <p:nvPr/>
        </p:nvSpPr>
        <p:spPr>
          <a:xfrm rot="8901917">
            <a:off x="2733570" y="1216248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二等辺三角形 26">
            <a:extLst>
              <a:ext uri="{FF2B5EF4-FFF2-40B4-BE49-F238E27FC236}">
                <a16:creationId xmlns:a16="http://schemas.microsoft.com/office/drawing/2014/main" id="{1A584FD4-29E3-9248-AFDE-796ACA6BB0E0}"/>
              </a:ext>
            </a:extLst>
          </p:cNvPr>
          <p:cNvSpPr>
            <a:spLocks noChangeAspect="1"/>
          </p:cNvSpPr>
          <p:nvPr/>
        </p:nvSpPr>
        <p:spPr>
          <a:xfrm rot="5215084">
            <a:off x="1536012" y="1296441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二等辺三角形 26">
            <a:extLst>
              <a:ext uri="{FF2B5EF4-FFF2-40B4-BE49-F238E27FC236}">
                <a16:creationId xmlns:a16="http://schemas.microsoft.com/office/drawing/2014/main" id="{EA3F68EE-E56F-A14F-A72D-028060E799DB}"/>
              </a:ext>
            </a:extLst>
          </p:cNvPr>
          <p:cNvSpPr>
            <a:spLocks noChangeAspect="1"/>
          </p:cNvSpPr>
          <p:nvPr/>
        </p:nvSpPr>
        <p:spPr>
          <a:xfrm rot="14875475">
            <a:off x="3057460" y="1364680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二等辺三角形 26">
            <a:extLst>
              <a:ext uri="{FF2B5EF4-FFF2-40B4-BE49-F238E27FC236}">
                <a16:creationId xmlns:a16="http://schemas.microsoft.com/office/drawing/2014/main" id="{61982590-9F6F-3544-9C1A-FB56936F13E3}"/>
              </a:ext>
            </a:extLst>
          </p:cNvPr>
          <p:cNvSpPr>
            <a:spLocks noChangeAspect="1"/>
          </p:cNvSpPr>
          <p:nvPr/>
        </p:nvSpPr>
        <p:spPr>
          <a:xfrm rot="14875475">
            <a:off x="3207492" y="1602804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二等辺三角形 26">
            <a:extLst>
              <a:ext uri="{FF2B5EF4-FFF2-40B4-BE49-F238E27FC236}">
                <a16:creationId xmlns:a16="http://schemas.microsoft.com/office/drawing/2014/main" id="{988E4354-D4E0-6D43-A0C2-A0DF60833787}"/>
              </a:ext>
            </a:extLst>
          </p:cNvPr>
          <p:cNvSpPr>
            <a:spLocks noChangeAspect="1"/>
          </p:cNvSpPr>
          <p:nvPr/>
        </p:nvSpPr>
        <p:spPr>
          <a:xfrm rot="5215084">
            <a:off x="2696901" y="1771945"/>
            <a:ext cx="48055" cy="110241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47535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812BE94-D3E1-1E41-B638-A06863D3B230}"/>
              </a:ext>
            </a:extLst>
          </p:cNvPr>
          <p:cNvSpPr txBox="1"/>
          <p:nvPr/>
        </p:nvSpPr>
        <p:spPr>
          <a:xfrm>
            <a:off x="1380369" y="46569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5B28C5A-AC66-9C46-B2C4-AA79E89E9650}"/>
              </a:ext>
            </a:extLst>
          </p:cNvPr>
          <p:cNvSpPr txBox="1"/>
          <p:nvPr/>
        </p:nvSpPr>
        <p:spPr>
          <a:xfrm>
            <a:off x="1391063" y="2993791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0F75A21-986E-F04E-8254-CAFFFAD8C6E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53544" y="677276"/>
            <a:ext cx="2114986" cy="1892441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8B26372-7851-7443-A62A-2778CD48D20C}"/>
              </a:ext>
            </a:extLst>
          </p:cNvPr>
          <p:cNvSpPr txBox="1"/>
          <p:nvPr/>
        </p:nvSpPr>
        <p:spPr>
          <a:xfrm>
            <a:off x="2315267" y="2623004"/>
            <a:ext cx="17491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Cyst: 1.42 cm×1.26 cm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8DF73F3-D91F-EE46-988B-874107ADF3AB}"/>
              </a:ext>
            </a:extLst>
          </p:cNvPr>
          <p:cNvSpPr txBox="1"/>
          <p:nvPr/>
        </p:nvSpPr>
        <p:spPr>
          <a:xfrm>
            <a:off x="5306396" y="2618467"/>
            <a:ext cx="13580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.09 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cm×2.38 cm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FA2EC078-FD4F-5840-BB6F-CB7F42714782}"/>
              </a:ext>
            </a:extLst>
          </p:cNvPr>
          <p:cNvCxnSpPr>
            <a:cxnSpLocks/>
          </p:cNvCxnSpPr>
          <p:nvPr/>
        </p:nvCxnSpPr>
        <p:spPr>
          <a:xfrm>
            <a:off x="4142009" y="2763880"/>
            <a:ext cx="99887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二等辺三角形 47">
            <a:extLst>
              <a:ext uri="{FF2B5EF4-FFF2-40B4-BE49-F238E27FC236}">
                <a16:creationId xmlns:a16="http://schemas.microsoft.com/office/drawing/2014/main" id="{A5DD011E-B629-C64F-99C9-EFFBB3932416}"/>
              </a:ext>
            </a:extLst>
          </p:cNvPr>
          <p:cNvSpPr>
            <a:spLocks noChangeAspect="1"/>
          </p:cNvSpPr>
          <p:nvPr/>
        </p:nvSpPr>
        <p:spPr>
          <a:xfrm rot="18245891" flipH="1">
            <a:off x="3545177" y="1404636"/>
            <a:ext cx="73372" cy="16832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A1725B7-4B09-C748-9744-C8A7813B568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00066" y="690370"/>
            <a:ext cx="2087067" cy="1896205"/>
          </a:xfrm>
          <a:prstGeom prst="rect">
            <a:avLst/>
          </a:prstGeom>
        </p:spPr>
      </p:pic>
      <p:sp>
        <p:nvSpPr>
          <p:cNvPr id="50" name="二等辺三角形 47">
            <a:extLst>
              <a:ext uri="{FF2B5EF4-FFF2-40B4-BE49-F238E27FC236}">
                <a16:creationId xmlns:a16="http://schemas.microsoft.com/office/drawing/2014/main" id="{D58F7360-8C62-EF4E-BEB7-7725D8A4A284}"/>
              </a:ext>
            </a:extLst>
          </p:cNvPr>
          <p:cNvSpPr>
            <a:spLocks noChangeAspect="1"/>
          </p:cNvSpPr>
          <p:nvPr/>
        </p:nvSpPr>
        <p:spPr>
          <a:xfrm rot="18290135" flipH="1">
            <a:off x="5693190" y="1642497"/>
            <a:ext cx="73372" cy="16832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09F5024-FDE8-5D4F-A647-2156BA383491}"/>
              </a:ext>
            </a:extLst>
          </p:cNvPr>
          <p:cNvSpPr/>
          <p:nvPr/>
        </p:nvSpPr>
        <p:spPr>
          <a:xfrm>
            <a:off x="1453750" y="5064642"/>
            <a:ext cx="144462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, not determined.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7824695-3D05-EF4B-AC27-BC1B7E27BA8B}"/>
              </a:ext>
            </a:extLst>
          </p:cNvPr>
          <p:cNvSpPr/>
          <p:nvPr/>
        </p:nvSpPr>
        <p:spPr>
          <a:xfrm>
            <a:off x="1453750" y="5249658"/>
            <a:ext cx="143500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, Male; F, Female.</a:t>
            </a: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830B8C06-BA00-5649-A23A-47AC0D59BA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4269447"/>
              </p:ext>
            </p:extLst>
          </p:nvPr>
        </p:nvGraphicFramePr>
        <p:xfrm>
          <a:off x="1453750" y="3279426"/>
          <a:ext cx="6184510" cy="1600200"/>
        </p:xfrm>
        <a:graphic>
          <a:graphicData uri="http://schemas.openxmlformats.org/drawingml/2006/table">
            <a:tbl>
              <a:tblPr/>
              <a:tblGrid>
                <a:gridCol w="1236902">
                  <a:extLst>
                    <a:ext uri="{9D8B030D-6E8A-4147-A177-3AD203B41FA5}">
                      <a16:colId xmlns:a16="http://schemas.microsoft.com/office/drawing/2014/main" val="1170377207"/>
                    </a:ext>
                  </a:extLst>
                </a:gridCol>
                <a:gridCol w="1236902">
                  <a:extLst>
                    <a:ext uri="{9D8B030D-6E8A-4147-A177-3AD203B41FA5}">
                      <a16:colId xmlns:a16="http://schemas.microsoft.com/office/drawing/2014/main" val="2670243133"/>
                    </a:ext>
                  </a:extLst>
                </a:gridCol>
                <a:gridCol w="1236902">
                  <a:extLst>
                    <a:ext uri="{9D8B030D-6E8A-4147-A177-3AD203B41FA5}">
                      <a16:colId xmlns:a16="http://schemas.microsoft.com/office/drawing/2014/main" val="2400289513"/>
                    </a:ext>
                  </a:extLst>
                </a:gridCol>
                <a:gridCol w="1236902">
                  <a:extLst>
                    <a:ext uri="{9D8B030D-6E8A-4147-A177-3AD203B41FA5}">
                      <a16:colId xmlns:a16="http://schemas.microsoft.com/office/drawing/2014/main" val="1382910556"/>
                    </a:ext>
                  </a:extLst>
                </a:gridCol>
                <a:gridCol w="1236902">
                  <a:extLst>
                    <a:ext uri="{9D8B030D-6E8A-4147-A177-3AD203B41FA5}">
                      <a16:colId xmlns:a16="http://schemas.microsoft.com/office/drawing/2014/main" val="3912750336"/>
                    </a:ext>
                  </a:extLst>
                </a:gridCol>
              </a:tblGrid>
              <a:tr h="2286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Pigs (Sex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onth of 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9602979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095933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W279 (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6070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W280 (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76967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W282 (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661798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W273 (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420113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W322 (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6048555"/>
                  </a:ext>
                </a:extLst>
              </a:tr>
            </a:tbl>
          </a:graphicData>
        </a:graphic>
      </p:graphicFrame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73F1A82D-DCB0-924C-B663-4D15E710B14A}"/>
              </a:ext>
            </a:extLst>
          </p:cNvPr>
          <p:cNvSpPr/>
          <p:nvPr/>
        </p:nvSpPr>
        <p:spPr>
          <a:xfrm>
            <a:off x="1453750" y="4879626"/>
            <a:ext cx="514789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 -, 0; +, 1-2; ++, 3-5;  +++, 6-9 or more macroscopic cysts in unilateral kidney.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30773D6-6F8A-8D40-9263-14E921CB6242}"/>
              </a:ext>
            </a:extLst>
          </p:cNvPr>
          <p:cNvSpPr txBox="1"/>
          <p:nvPr/>
        </p:nvSpPr>
        <p:spPr>
          <a:xfrm>
            <a:off x="2813000" y="435807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5 month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75B58A4-9D6A-9F4B-AEF3-9D8E762D93C6}"/>
              </a:ext>
            </a:extLst>
          </p:cNvPr>
          <p:cNvSpPr txBox="1"/>
          <p:nvPr/>
        </p:nvSpPr>
        <p:spPr>
          <a:xfrm>
            <a:off x="5531332" y="455919"/>
            <a:ext cx="8899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3 months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58AAAC6-709C-F74E-ADDF-1030F8D2FD55}"/>
              </a:ext>
            </a:extLst>
          </p:cNvPr>
          <p:cNvSpPr/>
          <p:nvPr/>
        </p:nvSpPr>
        <p:spPr>
          <a:xfrm>
            <a:off x="1380369" y="5743806"/>
            <a:ext cx="6257891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Supplementary Fig. S5 Progressive renal cyst development in </a:t>
            </a:r>
            <a:r>
              <a:rPr lang="en-US" altLang="ja-JP" sz="1100" b="1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b="1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1 mutant pigs.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A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Representative ultrasound diagnostic images of an expanding renal cyst (arrowhead) in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1 progeny (W322) at 5 months and 13 months of age.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B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The numbers of renal cysts at various stages of development. All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1 progeny showed progressive cyst development with animal growth.</a:t>
            </a:r>
            <a:r>
              <a:rPr lang="ja-JP" altLang="ja-JP" sz="1100"/>
              <a:t> </a:t>
            </a:r>
            <a:endParaRPr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40084130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747B92F-0CFF-E441-90FE-3749643B512D}"/>
              </a:ext>
            </a:extLst>
          </p:cNvPr>
          <p:cNvSpPr txBox="1"/>
          <p:nvPr/>
        </p:nvSpPr>
        <p:spPr>
          <a:xfrm>
            <a:off x="1063321" y="77103"/>
            <a:ext cx="4841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A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076E4DE-EB99-9D48-92A4-439BA30B527E}"/>
              </a:ext>
            </a:extLst>
          </p:cNvPr>
          <p:cNvSpPr txBox="1"/>
          <p:nvPr/>
        </p:nvSpPr>
        <p:spPr>
          <a:xfrm>
            <a:off x="1115266" y="1514515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</a:t>
            </a:r>
            <a:r>
              <a:rPr lang="en-US" altLang="ja-JP" sz="1100" b="1" dirty="0">
                <a:latin typeface="Arial"/>
                <a:cs typeface="Arial"/>
              </a:rPr>
              <a:t>B</a:t>
            </a:r>
            <a:r>
              <a:rPr kumimoji="1" lang="en-US" altLang="ja-JP" sz="1100" b="1" dirty="0">
                <a:latin typeface="Arial"/>
                <a:cs typeface="Arial"/>
              </a:rPr>
              <a:t>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611C56DC-2726-C84B-B1A3-7CA67F9219B7}"/>
              </a:ext>
            </a:extLst>
          </p:cNvPr>
          <p:cNvGrpSpPr/>
          <p:nvPr/>
        </p:nvGrpSpPr>
        <p:grpSpPr>
          <a:xfrm>
            <a:off x="1389776" y="1738760"/>
            <a:ext cx="3087220" cy="3508099"/>
            <a:chOff x="1442373" y="1855209"/>
            <a:chExt cx="2848648" cy="3237003"/>
          </a:xfrm>
        </p:grpSpPr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D262C6A9-611B-1B4D-943E-74CEA849F75E}"/>
                </a:ext>
              </a:extLst>
            </p:cNvPr>
            <p:cNvGrpSpPr/>
            <p:nvPr/>
          </p:nvGrpSpPr>
          <p:grpSpPr>
            <a:xfrm>
              <a:off x="1442991" y="1855209"/>
              <a:ext cx="1409125" cy="1056844"/>
              <a:chOff x="356365" y="2723864"/>
              <a:chExt cx="2406621" cy="1804966"/>
            </a:xfrm>
          </p:grpSpPr>
          <p:pic>
            <p:nvPicPr>
              <p:cNvPr id="72" name="図 71">
                <a:extLst>
                  <a:ext uri="{FF2B5EF4-FFF2-40B4-BE49-F238E27FC236}">
                    <a16:creationId xmlns:a16="http://schemas.microsoft.com/office/drawing/2014/main" id="{6D00A1B5-7251-7242-AFEE-15E727CB50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6365" y="2723864"/>
                <a:ext cx="2406621" cy="1804966"/>
              </a:xfrm>
              <a:prstGeom prst="rect">
                <a:avLst/>
              </a:prstGeom>
            </p:spPr>
          </p:pic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id="{AE24037E-7F67-B449-A344-AEDDE86E5FA0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2547825" y="4280053"/>
                <a:ext cx="0" cy="29656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BD308049-5E56-7343-8B06-DAADAB8E21B9}"/>
                </a:ext>
              </a:extLst>
            </p:cNvPr>
            <p:cNvSpPr txBox="1"/>
            <p:nvPr/>
          </p:nvSpPr>
          <p:spPr>
            <a:xfrm>
              <a:off x="1442992" y="1855209"/>
              <a:ext cx="469382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1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CC4C27A9-7432-8F4E-9CD6-6B89A1E2CF96}"/>
                </a:ext>
              </a:extLst>
            </p:cNvPr>
            <p:cNvGrpSpPr/>
            <p:nvPr/>
          </p:nvGrpSpPr>
          <p:grpSpPr>
            <a:xfrm>
              <a:off x="2873595" y="1855209"/>
              <a:ext cx="1409125" cy="1056844"/>
              <a:chOff x="3421699" y="2891850"/>
              <a:chExt cx="2511939" cy="1883954"/>
            </a:xfrm>
          </p:grpSpPr>
          <p:pic>
            <p:nvPicPr>
              <p:cNvPr id="73" name="図 72">
                <a:extLst>
                  <a:ext uri="{FF2B5EF4-FFF2-40B4-BE49-F238E27FC236}">
                    <a16:creationId xmlns:a16="http://schemas.microsoft.com/office/drawing/2014/main" id="{EAE137C4-26B2-5F41-BCD2-5FEC14DAC9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21699" y="2891850"/>
                <a:ext cx="2511939" cy="1883954"/>
              </a:xfrm>
              <a:prstGeom prst="rect">
                <a:avLst/>
              </a:prstGeom>
            </p:spPr>
          </p:pic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id="{A9F1F462-DBDF-1449-828B-B6CA25B9694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V="1">
                <a:off x="5659092" y="4507263"/>
                <a:ext cx="2" cy="309993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二等辺三角形 26">
              <a:extLst>
                <a:ext uri="{FF2B5EF4-FFF2-40B4-BE49-F238E27FC236}">
                  <a16:creationId xmlns:a16="http://schemas.microsoft.com/office/drawing/2014/main" id="{8BF13B4A-4133-194F-B80E-FD9F7F18E14A}"/>
                </a:ext>
              </a:extLst>
            </p:cNvPr>
            <p:cNvSpPr>
              <a:spLocks noChangeAspect="1"/>
            </p:cNvSpPr>
            <p:nvPr/>
          </p:nvSpPr>
          <p:spPr>
            <a:xfrm rot="15300000">
              <a:off x="2721338" y="2610221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3712D912-FADA-3A45-B2DD-871418E43789}"/>
                </a:ext>
              </a:extLst>
            </p:cNvPr>
            <p:cNvSpPr txBox="1"/>
            <p:nvPr/>
          </p:nvSpPr>
          <p:spPr>
            <a:xfrm>
              <a:off x="2873594" y="1855209"/>
              <a:ext cx="470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2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二等辺三角形 26">
              <a:extLst>
                <a:ext uri="{FF2B5EF4-FFF2-40B4-BE49-F238E27FC236}">
                  <a16:creationId xmlns:a16="http://schemas.microsoft.com/office/drawing/2014/main" id="{E0FE3F2C-AA13-1143-A981-1FB1AE1D8807}"/>
                </a:ext>
              </a:extLst>
            </p:cNvPr>
            <p:cNvSpPr>
              <a:spLocks noChangeAspect="1"/>
            </p:cNvSpPr>
            <p:nvPr/>
          </p:nvSpPr>
          <p:spPr>
            <a:xfrm rot="16200000">
              <a:off x="4152538" y="2354941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17CB5860-B808-9E47-B022-8737F200360E}"/>
                </a:ext>
              </a:extLst>
            </p:cNvPr>
            <p:cNvGrpSpPr/>
            <p:nvPr/>
          </p:nvGrpSpPr>
          <p:grpSpPr>
            <a:xfrm>
              <a:off x="1442373" y="2938178"/>
              <a:ext cx="1410070" cy="1057553"/>
              <a:chOff x="5813920" y="2530110"/>
              <a:chExt cx="2711278" cy="2033460"/>
            </a:xfrm>
          </p:grpSpPr>
          <p:pic>
            <p:nvPicPr>
              <p:cNvPr id="77" name="図 76">
                <a:extLst>
                  <a:ext uri="{FF2B5EF4-FFF2-40B4-BE49-F238E27FC236}">
                    <a16:creationId xmlns:a16="http://schemas.microsoft.com/office/drawing/2014/main" id="{A165FC3B-6E8F-9545-9AEA-3DE717592F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813920" y="2530110"/>
                <a:ext cx="2711278" cy="2033460"/>
              </a:xfrm>
              <a:prstGeom prst="rect">
                <a:avLst/>
              </a:prstGeom>
            </p:spPr>
          </p:pic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DC3A8E2C-7043-A943-8F3A-FEF6B1D91153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8293883" y="4283255"/>
                <a:ext cx="0" cy="31811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A5BB2C4E-7FB2-3742-8F47-DE8340645152}"/>
                </a:ext>
              </a:extLst>
            </p:cNvPr>
            <p:cNvSpPr txBox="1"/>
            <p:nvPr/>
          </p:nvSpPr>
          <p:spPr>
            <a:xfrm>
              <a:off x="1442373" y="2933443"/>
              <a:ext cx="470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3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二等辺三角形 26">
              <a:extLst>
                <a:ext uri="{FF2B5EF4-FFF2-40B4-BE49-F238E27FC236}">
                  <a16:creationId xmlns:a16="http://schemas.microsoft.com/office/drawing/2014/main" id="{EB470C5D-8F6F-E24A-AAFB-FAD45D3BC907}"/>
                </a:ext>
              </a:extLst>
            </p:cNvPr>
            <p:cNvSpPr>
              <a:spLocks noChangeAspect="1"/>
            </p:cNvSpPr>
            <p:nvPr/>
          </p:nvSpPr>
          <p:spPr>
            <a:xfrm rot="13500000">
              <a:off x="1966945" y="3193402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9B25435C-7C15-0748-A936-FF48AAEFB2FB}"/>
                </a:ext>
              </a:extLst>
            </p:cNvPr>
            <p:cNvGrpSpPr/>
            <p:nvPr/>
          </p:nvGrpSpPr>
          <p:grpSpPr>
            <a:xfrm>
              <a:off x="2873594" y="2937629"/>
              <a:ext cx="1410802" cy="1058102"/>
              <a:chOff x="443643" y="4591140"/>
              <a:chExt cx="2473481" cy="1855112"/>
            </a:xfrm>
          </p:grpSpPr>
          <p:pic>
            <p:nvPicPr>
              <p:cNvPr id="83" name="図 82">
                <a:extLst>
                  <a:ext uri="{FF2B5EF4-FFF2-40B4-BE49-F238E27FC236}">
                    <a16:creationId xmlns:a16="http://schemas.microsoft.com/office/drawing/2014/main" id="{48DC8770-DDA4-0941-B654-90A872EE00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3643" y="4591140"/>
                <a:ext cx="2473481" cy="1855112"/>
              </a:xfrm>
              <a:prstGeom prst="rect">
                <a:avLst/>
              </a:prstGeom>
            </p:spPr>
          </p:pic>
          <p:cxnSp>
            <p:nvCxnSpPr>
              <p:cNvPr id="84" name="直線コネクタ 83">
                <a:extLst>
                  <a:ext uri="{FF2B5EF4-FFF2-40B4-BE49-F238E27FC236}">
                    <a16:creationId xmlns:a16="http://schemas.microsoft.com/office/drawing/2014/main" id="{C844B94D-5444-764E-92F8-5EF0FC34D83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2637005" y="6189888"/>
                <a:ext cx="0" cy="330517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3E51CD50-B5FE-5F4E-B564-DAA57156EB31}"/>
                </a:ext>
              </a:extLst>
            </p:cNvPr>
            <p:cNvSpPr txBox="1"/>
            <p:nvPr/>
          </p:nvSpPr>
          <p:spPr>
            <a:xfrm>
              <a:off x="2873594" y="2932514"/>
              <a:ext cx="470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4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二等辺三角形 26">
              <a:extLst>
                <a:ext uri="{FF2B5EF4-FFF2-40B4-BE49-F238E27FC236}">
                  <a16:creationId xmlns:a16="http://schemas.microsoft.com/office/drawing/2014/main" id="{51ACA35E-5182-FC4B-9288-6423DCB035EE}"/>
                </a:ext>
              </a:extLst>
            </p:cNvPr>
            <p:cNvSpPr>
              <a:spLocks noChangeAspect="1"/>
            </p:cNvSpPr>
            <p:nvPr/>
          </p:nvSpPr>
          <p:spPr>
            <a:xfrm rot="18749487">
              <a:off x="3330049" y="3405191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グループ化 87">
              <a:extLst>
                <a:ext uri="{FF2B5EF4-FFF2-40B4-BE49-F238E27FC236}">
                  <a16:creationId xmlns:a16="http://schemas.microsoft.com/office/drawing/2014/main" id="{E3251FD9-F602-5C40-8B68-65A27E3A2E9A}"/>
                </a:ext>
              </a:extLst>
            </p:cNvPr>
            <p:cNvGrpSpPr/>
            <p:nvPr/>
          </p:nvGrpSpPr>
          <p:grpSpPr>
            <a:xfrm>
              <a:off x="1442373" y="4034628"/>
              <a:ext cx="1410112" cy="1057584"/>
              <a:chOff x="3604955" y="4425850"/>
              <a:chExt cx="2766379" cy="2074785"/>
            </a:xfrm>
          </p:grpSpPr>
          <p:pic>
            <p:nvPicPr>
              <p:cNvPr id="86" name="図 85">
                <a:extLst>
                  <a:ext uri="{FF2B5EF4-FFF2-40B4-BE49-F238E27FC236}">
                    <a16:creationId xmlns:a16="http://schemas.microsoft.com/office/drawing/2014/main" id="{30CA0C0E-4E98-7247-BCF0-65B7C3A6B6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04955" y="4425850"/>
                <a:ext cx="2766379" cy="2074785"/>
              </a:xfrm>
              <a:prstGeom prst="rect">
                <a:avLst/>
              </a:prstGeom>
            </p:spPr>
          </p:pic>
          <p:cxnSp>
            <p:nvCxnSpPr>
              <p:cNvPr id="87" name="直線コネクタ 86">
                <a:extLst>
                  <a:ext uri="{FF2B5EF4-FFF2-40B4-BE49-F238E27FC236}">
                    <a16:creationId xmlns:a16="http://schemas.microsoft.com/office/drawing/2014/main" id="{E7327307-5B2B-2E4E-A91E-04BEB8C03EA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6098432" y="6242075"/>
                <a:ext cx="0" cy="331033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DA7D5E04-DF97-384F-90CE-83496D90D3AC}"/>
                </a:ext>
              </a:extLst>
            </p:cNvPr>
            <p:cNvSpPr txBox="1"/>
            <p:nvPr/>
          </p:nvSpPr>
          <p:spPr>
            <a:xfrm>
              <a:off x="1442373" y="4028993"/>
              <a:ext cx="4700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6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二等辺三角形 26">
              <a:extLst>
                <a:ext uri="{FF2B5EF4-FFF2-40B4-BE49-F238E27FC236}">
                  <a16:creationId xmlns:a16="http://schemas.microsoft.com/office/drawing/2014/main" id="{4A9B1624-6A75-224B-AEC6-66A529D5BD72}"/>
                </a:ext>
              </a:extLst>
            </p:cNvPr>
            <p:cNvSpPr>
              <a:spLocks noChangeAspect="1"/>
            </p:cNvSpPr>
            <p:nvPr/>
          </p:nvSpPr>
          <p:spPr>
            <a:xfrm rot="2700000">
              <a:off x="1630589" y="4869927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1" name="グループ化 90">
              <a:extLst>
                <a:ext uri="{FF2B5EF4-FFF2-40B4-BE49-F238E27FC236}">
                  <a16:creationId xmlns:a16="http://schemas.microsoft.com/office/drawing/2014/main" id="{77C0DA0A-15A3-3143-972E-D38B84FCD4D3}"/>
                </a:ext>
              </a:extLst>
            </p:cNvPr>
            <p:cNvGrpSpPr/>
            <p:nvPr/>
          </p:nvGrpSpPr>
          <p:grpSpPr>
            <a:xfrm>
              <a:off x="2880219" y="4034110"/>
              <a:ext cx="1410802" cy="1058102"/>
              <a:chOff x="6003949" y="4528009"/>
              <a:chExt cx="2432532" cy="1824400"/>
            </a:xfrm>
          </p:grpSpPr>
          <p:pic>
            <p:nvPicPr>
              <p:cNvPr id="89" name="図 88">
                <a:extLst>
                  <a:ext uri="{FF2B5EF4-FFF2-40B4-BE49-F238E27FC236}">
                    <a16:creationId xmlns:a16="http://schemas.microsoft.com/office/drawing/2014/main" id="{DFB60F9C-8080-0241-8BC2-A67552A743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screen">
                <a:alphaModFix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03949" y="4528009"/>
                <a:ext cx="2432532" cy="1824400"/>
              </a:xfrm>
              <a:prstGeom prst="rect">
                <a:avLst/>
              </a:prstGeom>
            </p:spPr>
          </p:pic>
          <p:cxnSp>
            <p:nvCxnSpPr>
              <p:cNvPr id="90" name="直線コネクタ 89">
                <a:extLst>
                  <a:ext uri="{FF2B5EF4-FFF2-40B4-BE49-F238E27FC236}">
                    <a16:creationId xmlns:a16="http://schemas.microsoft.com/office/drawing/2014/main" id="{6ECA0F89-A07D-A740-82EA-F8F9BCCA326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8187069" y="6084103"/>
                <a:ext cx="0" cy="34167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6E92CCD9-82AD-5248-B75D-E2A9A6A3250B}"/>
                </a:ext>
              </a:extLst>
            </p:cNvPr>
            <p:cNvSpPr txBox="1"/>
            <p:nvPr/>
          </p:nvSpPr>
          <p:spPr>
            <a:xfrm>
              <a:off x="2891037" y="4034110"/>
              <a:ext cx="471600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730-9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二等辺三角形 26">
              <a:extLst>
                <a:ext uri="{FF2B5EF4-FFF2-40B4-BE49-F238E27FC236}">
                  <a16:creationId xmlns:a16="http://schemas.microsoft.com/office/drawing/2014/main" id="{54C48F1D-4C84-2C41-980C-B95928D27370}"/>
                </a:ext>
              </a:extLst>
            </p:cNvPr>
            <p:cNvSpPr>
              <a:spLocks noChangeAspect="1"/>
            </p:cNvSpPr>
            <p:nvPr/>
          </p:nvSpPr>
          <p:spPr>
            <a:xfrm rot="7200000">
              <a:off x="3341190" y="4312642"/>
              <a:ext cx="44341" cy="101722"/>
            </a:xfrm>
            <a:prstGeom prst="triangl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0D241C6E-900C-A74B-9B3D-04E7182613FA}"/>
              </a:ext>
            </a:extLst>
          </p:cNvPr>
          <p:cNvSpPr/>
          <p:nvPr/>
        </p:nvSpPr>
        <p:spPr>
          <a:xfrm>
            <a:off x="991773" y="5315245"/>
            <a:ext cx="7230793" cy="14927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</a:pP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Fig. S6 Reproductive performance of </a:t>
            </a:r>
            <a:r>
              <a:rPr lang="en-US" altLang="ja-JP" sz="1100" b="1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b="1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</a:t>
            </a: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F1 mutant pigs and neonatal cyst formation of the F2 progeny.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(</a:t>
            </a: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The neonatal </a:t>
            </a:r>
            <a:r>
              <a:rPr lang="en-US" altLang="ja-JP" sz="11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2 pig progeny produced by mating </a:t>
            </a:r>
            <a:r>
              <a:rPr lang="en-US" altLang="ja-JP" sz="11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1 boar (W279) with WT gilt (#1730). Six of the nine piglets were confirmed by PCR-RFLP analysis to be of the </a:t>
            </a:r>
            <a:r>
              <a:rPr lang="en-US" altLang="ja-JP" sz="11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genotype. (</a:t>
            </a: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The gross morphology of the kidneys in the </a:t>
            </a:r>
            <a:r>
              <a:rPr lang="en-US" altLang="ja-JP" sz="11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2 progeny at 3 days of age. All of the </a:t>
            </a:r>
            <a:r>
              <a:rPr lang="en-US" altLang="ja-JP" sz="11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1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2 piglets showed renal cyst formation. Yellow arrowhead indicates renal cysts. The bars are 1 cm. </a:t>
            </a:r>
            <a:r>
              <a:rPr lang="en-US" altLang="ja-JP" sz="11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(C) 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Sections of hematoxylin-eosin staining of the kidney in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the </a:t>
            </a:r>
            <a:r>
              <a:rPr lang="en-US" altLang="ja-JP" sz="12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PKD1</a:t>
            </a:r>
            <a:r>
              <a:rPr lang="en-US" altLang="ja-JP" sz="1200" i="1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sG/+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2 progeny (#1730-2 and #1730-3) at 3 days of age and age-matched WT pig (#1730-5)</a:t>
            </a:r>
            <a:r>
              <a:rPr lang="en-US" altLang="ja-JP" sz="12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. Black arrowhead represents renal cysts. Bars indicate 5 mm.</a:t>
            </a:r>
            <a:endParaRPr lang="ja-JP" altLang="ja-JP" sz="12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60F06B53-6CE3-2343-83FC-6DCE87E9F3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8260320"/>
              </p:ext>
            </p:extLst>
          </p:nvPr>
        </p:nvGraphicFramePr>
        <p:xfrm>
          <a:off x="1411179" y="384751"/>
          <a:ext cx="6501418" cy="912763"/>
        </p:xfrm>
        <a:graphic>
          <a:graphicData uri="http://schemas.openxmlformats.org/drawingml/2006/table">
            <a:tbl>
              <a:tblPr/>
              <a:tblGrid>
                <a:gridCol w="1161695">
                  <a:extLst>
                    <a:ext uri="{9D8B030D-6E8A-4147-A177-3AD203B41FA5}">
                      <a16:colId xmlns:a16="http://schemas.microsoft.com/office/drawing/2014/main" val="2335006836"/>
                    </a:ext>
                  </a:extLst>
                </a:gridCol>
                <a:gridCol w="1161695">
                  <a:extLst>
                    <a:ext uri="{9D8B030D-6E8A-4147-A177-3AD203B41FA5}">
                      <a16:colId xmlns:a16="http://schemas.microsoft.com/office/drawing/2014/main" val="1756355883"/>
                    </a:ext>
                  </a:extLst>
                </a:gridCol>
                <a:gridCol w="978270">
                  <a:extLst>
                    <a:ext uri="{9D8B030D-6E8A-4147-A177-3AD203B41FA5}">
                      <a16:colId xmlns:a16="http://schemas.microsoft.com/office/drawing/2014/main" val="3298695728"/>
                    </a:ext>
                  </a:extLst>
                </a:gridCol>
                <a:gridCol w="1599879">
                  <a:extLst>
                    <a:ext uri="{9D8B030D-6E8A-4147-A177-3AD203B41FA5}">
                      <a16:colId xmlns:a16="http://schemas.microsoft.com/office/drawing/2014/main" val="189536013"/>
                    </a:ext>
                  </a:extLst>
                </a:gridCol>
                <a:gridCol w="1599879">
                  <a:extLst>
                    <a:ext uri="{9D8B030D-6E8A-4147-A177-3AD203B41FA5}">
                      <a16:colId xmlns:a16="http://schemas.microsoft.com/office/drawing/2014/main" val="1386982373"/>
                    </a:ext>
                  </a:extLst>
                </a:gridCol>
              </a:tblGrid>
              <a:tr h="241107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Breeding pair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itter size 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enotype (F2 pigs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9053227"/>
                  </a:ext>
                </a:extLst>
              </a:tr>
              <a:tr h="24110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♂ (</a:t>
                      </a:r>
                      <a:r>
                        <a:rPr lang="en-US" sz="11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b="1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insG/+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♀ (</a:t>
                      </a:r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+/+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insG/+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KD1</a:t>
                      </a:r>
                      <a:r>
                        <a:rPr lang="en-US" sz="11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+/+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327877"/>
                  </a:ext>
                </a:extLst>
              </a:tr>
              <a:tr h="43054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W279 (F1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#1730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 (♂4</a:t>
                      </a: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Arial" panose="020B0604020202020204" pitchFamily="34" charset="0"/>
                        </a:rPr>
                        <a:t>：</a:t>
                      </a: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 (♂2</a:t>
                      </a:r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：♀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)</a:t>
                      </a:r>
                    </a:p>
                  </a:txBody>
                  <a:tcPr marL="9271" marR="9271" marT="9271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8445107"/>
                  </a:ext>
                </a:extLst>
              </a:tr>
            </a:tbl>
          </a:graphicData>
        </a:graphic>
      </p:graphicFrame>
      <p:pic>
        <p:nvPicPr>
          <p:cNvPr id="39" name="図 38">
            <a:extLst>
              <a:ext uri="{FF2B5EF4-FFF2-40B4-BE49-F238E27FC236}">
                <a16:creationId xmlns:a16="http://schemas.microsoft.com/office/drawing/2014/main" id="{46AACDA4-E82B-C040-A695-C9E5DD02E80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15081" y="1744305"/>
            <a:ext cx="2397517" cy="114535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036C136-2ED7-1E40-8C03-AC9944ECFC6F}"/>
              </a:ext>
            </a:extLst>
          </p:cNvPr>
          <p:cNvSpPr txBox="1"/>
          <p:nvPr/>
        </p:nvSpPr>
        <p:spPr>
          <a:xfrm>
            <a:off x="4881391" y="2219108"/>
            <a:ext cx="702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#1730-2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8CBC455F-B1DA-8944-99DE-AFC44EB7EEA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18355" y="4100141"/>
            <a:ext cx="2394243" cy="114671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E37532D5-2102-9246-8D33-A534C09F595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15081" y="2916937"/>
            <a:ext cx="2397517" cy="1145734"/>
          </a:xfrm>
          <a:prstGeom prst="rect">
            <a:avLst/>
          </a:prstGeom>
        </p:spPr>
      </p:pic>
      <p:sp>
        <p:nvSpPr>
          <p:cNvPr id="49" name="二等辺三角形 26">
            <a:extLst>
              <a:ext uri="{FF2B5EF4-FFF2-40B4-BE49-F238E27FC236}">
                <a16:creationId xmlns:a16="http://schemas.microsoft.com/office/drawing/2014/main" id="{E0ADEA7D-4B88-514C-A07D-DCE40E88B7F6}"/>
              </a:ext>
            </a:extLst>
          </p:cNvPr>
          <p:cNvSpPr>
            <a:spLocks noChangeAspect="1"/>
          </p:cNvSpPr>
          <p:nvPr/>
        </p:nvSpPr>
        <p:spPr>
          <a:xfrm rot="6220559">
            <a:off x="6771331" y="2571389"/>
            <a:ext cx="78463" cy="1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90ECBBD-939B-DD4B-9271-11183E12806F}"/>
              </a:ext>
            </a:extLst>
          </p:cNvPr>
          <p:cNvSpPr txBox="1"/>
          <p:nvPr/>
        </p:nvSpPr>
        <p:spPr>
          <a:xfrm>
            <a:off x="4818202" y="1514515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C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F2D31CD-C85B-AF4B-9805-67CD1D59B098}"/>
              </a:ext>
            </a:extLst>
          </p:cNvPr>
          <p:cNvSpPr txBox="1"/>
          <p:nvPr/>
        </p:nvSpPr>
        <p:spPr>
          <a:xfrm>
            <a:off x="4872771" y="3402312"/>
            <a:ext cx="702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#1730-3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E24345E-30CB-2543-A4A0-84C68EE6E26A}"/>
              </a:ext>
            </a:extLst>
          </p:cNvPr>
          <p:cNvSpPr txBox="1"/>
          <p:nvPr/>
        </p:nvSpPr>
        <p:spPr>
          <a:xfrm>
            <a:off x="5109915" y="4576888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D55D26C6-56EA-DC4E-9C95-BCC2B42E38C7}"/>
              </a:ext>
            </a:extLst>
          </p:cNvPr>
          <p:cNvCxnSpPr>
            <a:cxnSpLocks/>
          </p:cNvCxnSpPr>
          <p:nvPr/>
        </p:nvCxnSpPr>
        <p:spPr>
          <a:xfrm>
            <a:off x="7485708" y="5185597"/>
            <a:ext cx="36452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二等辺三角形 26">
            <a:extLst>
              <a:ext uri="{FF2B5EF4-FFF2-40B4-BE49-F238E27FC236}">
                <a16:creationId xmlns:a16="http://schemas.microsoft.com/office/drawing/2014/main" id="{08D66E1E-12BE-834A-BD5F-ABEB7CC436B4}"/>
              </a:ext>
            </a:extLst>
          </p:cNvPr>
          <p:cNvSpPr>
            <a:spLocks noChangeAspect="1"/>
          </p:cNvSpPr>
          <p:nvPr/>
        </p:nvSpPr>
        <p:spPr>
          <a:xfrm rot="1701988">
            <a:off x="5988721" y="3308844"/>
            <a:ext cx="78463" cy="180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848FE34-1C99-BD4A-B99C-325DDADC2768}"/>
              </a:ext>
            </a:extLst>
          </p:cNvPr>
          <p:cNvCxnSpPr>
            <a:cxnSpLocks/>
          </p:cNvCxnSpPr>
          <p:nvPr/>
        </p:nvCxnSpPr>
        <p:spPr>
          <a:xfrm>
            <a:off x="7485708" y="3984032"/>
            <a:ext cx="36452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966A68C5-8746-C446-BA43-B9B133CCE963}"/>
              </a:ext>
            </a:extLst>
          </p:cNvPr>
          <p:cNvCxnSpPr>
            <a:cxnSpLocks/>
          </p:cNvCxnSpPr>
          <p:nvPr/>
        </p:nvCxnSpPr>
        <p:spPr>
          <a:xfrm>
            <a:off x="7485708" y="2792653"/>
            <a:ext cx="36452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72146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9D8C01D-5828-2F48-BF45-5F4D1064F311}"/>
              </a:ext>
            </a:extLst>
          </p:cNvPr>
          <p:cNvGrpSpPr/>
          <p:nvPr/>
        </p:nvGrpSpPr>
        <p:grpSpPr>
          <a:xfrm>
            <a:off x="1680491" y="996436"/>
            <a:ext cx="2759332" cy="2069499"/>
            <a:chOff x="1280240" y="1002459"/>
            <a:chExt cx="2534737" cy="1901053"/>
          </a:xfrm>
        </p:grpSpPr>
        <p:pic>
          <p:nvPicPr>
            <p:cNvPr id="94" name="図 93">
              <a:extLst>
                <a:ext uri="{FF2B5EF4-FFF2-40B4-BE49-F238E27FC236}">
                  <a16:creationId xmlns:a16="http://schemas.microsoft.com/office/drawing/2014/main" id="{CD794092-5F2C-1D4E-A1F0-832DA4071AE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80240" y="1002459"/>
              <a:ext cx="2534737" cy="1901053"/>
            </a:xfrm>
            <a:prstGeom prst="rect">
              <a:avLst/>
            </a:prstGeom>
          </p:spPr>
        </p:pic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467863E1-0F54-BF43-B0C7-61B34167F09A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552528" y="2652887"/>
              <a:ext cx="0" cy="360876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FC4D0EE-9365-8D42-BC39-FD6FF8F88D65}"/>
              </a:ext>
            </a:extLst>
          </p:cNvPr>
          <p:cNvGrpSpPr/>
          <p:nvPr/>
        </p:nvGrpSpPr>
        <p:grpSpPr>
          <a:xfrm>
            <a:off x="4517847" y="999008"/>
            <a:ext cx="2755902" cy="2066927"/>
            <a:chOff x="5935844" y="3782786"/>
            <a:chExt cx="2526649" cy="1894987"/>
          </a:xfrm>
        </p:grpSpPr>
        <p:pic>
          <p:nvPicPr>
            <p:cNvPr id="97" name="図 96">
              <a:extLst>
                <a:ext uri="{FF2B5EF4-FFF2-40B4-BE49-F238E27FC236}">
                  <a16:creationId xmlns:a16="http://schemas.microsoft.com/office/drawing/2014/main" id="{30BD891F-F2A5-DD42-AD60-DCD28DA275B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35844" y="3782786"/>
              <a:ext cx="2526649" cy="1894987"/>
            </a:xfrm>
            <a:prstGeom prst="rect">
              <a:avLst/>
            </a:prstGeom>
          </p:spPr>
        </p:pic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571B8AC7-812A-AF42-85F5-596FF25F80DE}"/>
                </a:ext>
              </a:extLst>
            </p:cNvPr>
            <p:cNvCxnSpPr>
              <a:cxnSpLocks/>
            </p:cNvCxnSpPr>
            <p:nvPr/>
          </p:nvCxnSpPr>
          <p:spPr>
            <a:xfrm>
              <a:off x="7877417" y="5612511"/>
              <a:ext cx="485046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3757066-6224-DC42-8ACB-EA562D5A2A53}"/>
              </a:ext>
            </a:extLst>
          </p:cNvPr>
          <p:cNvSpPr txBox="1"/>
          <p:nvPr/>
        </p:nvSpPr>
        <p:spPr>
          <a:xfrm>
            <a:off x="4453951" y="986811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B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7E38EAA5-B5DA-BB4C-BF1E-F0AE3BF350E4}"/>
              </a:ext>
            </a:extLst>
          </p:cNvPr>
          <p:cNvSpPr txBox="1"/>
          <p:nvPr/>
        </p:nvSpPr>
        <p:spPr>
          <a:xfrm>
            <a:off x="1624288" y="986811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</a:t>
            </a:r>
            <a:r>
              <a:rPr lang="en-US" altLang="ja-JP" sz="1100" b="1" dirty="0">
                <a:latin typeface="Arial"/>
                <a:cs typeface="Arial"/>
              </a:rPr>
              <a:t>A</a:t>
            </a:r>
            <a:r>
              <a:rPr kumimoji="1" lang="en-US" altLang="ja-JP" sz="1100" b="1" dirty="0">
                <a:latin typeface="Arial"/>
                <a:cs typeface="Arial"/>
              </a:rPr>
              <a:t>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C004DE88-E28D-3840-B909-7BD0A940EEE6}"/>
              </a:ext>
            </a:extLst>
          </p:cNvPr>
          <p:cNvGrpSpPr/>
          <p:nvPr/>
        </p:nvGrpSpPr>
        <p:grpSpPr>
          <a:xfrm>
            <a:off x="1681202" y="3129723"/>
            <a:ext cx="2754058" cy="2065543"/>
            <a:chOff x="887716" y="4660928"/>
            <a:chExt cx="2534737" cy="1901052"/>
          </a:xfrm>
        </p:grpSpPr>
        <p:pic>
          <p:nvPicPr>
            <p:cNvPr id="101" name="図 100">
              <a:extLst>
                <a:ext uri="{FF2B5EF4-FFF2-40B4-BE49-F238E27FC236}">
                  <a16:creationId xmlns:a16="http://schemas.microsoft.com/office/drawing/2014/main" id="{CB66B9D7-19DD-2B4A-9B01-20B3B2BC2B2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87716" y="4660928"/>
              <a:ext cx="2534737" cy="1901052"/>
            </a:xfrm>
            <a:prstGeom prst="rect">
              <a:avLst/>
            </a:prstGeom>
          </p:spPr>
        </p:pic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E083EDBB-1606-6446-B60C-BAE694546111}"/>
                </a:ext>
              </a:extLst>
            </p:cNvPr>
            <p:cNvCxnSpPr/>
            <p:nvPr/>
          </p:nvCxnSpPr>
          <p:spPr>
            <a:xfrm>
              <a:off x="2744814" y="6475859"/>
              <a:ext cx="597118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C47A57DF-3A76-3145-A987-CC0D76A5A6FB}"/>
              </a:ext>
            </a:extLst>
          </p:cNvPr>
          <p:cNvSpPr txBox="1"/>
          <p:nvPr/>
        </p:nvSpPr>
        <p:spPr>
          <a:xfrm>
            <a:off x="1624288" y="3097022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</a:t>
            </a:r>
            <a:r>
              <a:rPr lang="en-US" altLang="ja-JP" sz="1100" b="1" dirty="0">
                <a:latin typeface="Arial"/>
                <a:cs typeface="Arial"/>
              </a:rPr>
              <a:t>C</a:t>
            </a:r>
            <a:r>
              <a:rPr kumimoji="1" lang="en-US" altLang="ja-JP" sz="1100" b="1" dirty="0">
                <a:latin typeface="Arial"/>
                <a:cs typeface="Arial"/>
              </a:rPr>
              <a:t>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4BD5F7BD-4D56-E840-9D7A-2B891492DE3C}"/>
              </a:ext>
            </a:extLst>
          </p:cNvPr>
          <p:cNvSpPr txBox="1"/>
          <p:nvPr/>
        </p:nvSpPr>
        <p:spPr>
          <a:xfrm>
            <a:off x="3444454" y="4375565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72D5CC2-AA5C-B646-A2A3-CF5DC5C500BF}"/>
              </a:ext>
            </a:extLst>
          </p:cNvPr>
          <p:cNvSpPr txBox="1"/>
          <p:nvPr/>
        </p:nvSpPr>
        <p:spPr>
          <a:xfrm>
            <a:off x="2173332" y="3814804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F21BADF8-EBCE-C44F-8F64-A359870AA6EA}"/>
              </a:ext>
            </a:extLst>
          </p:cNvPr>
          <p:cNvSpPr txBox="1"/>
          <p:nvPr/>
        </p:nvSpPr>
        <p:spPr>
          <a:xfrm>
            <a:off x="1639356" y="4571594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3E080E29-8A3C-C147-9B40-B405B78314F2}"/>
              </a:ext>
            </a:extLst>
          </p:cNvPr>
          <p:cNvSpPr txBox="1"/>
          <p:nvPr/>
        </p:nvSpPr>
        <p:spPr>
          <a:xfrm>
            <a:off x="2004129" y="3542862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207C28D-8E5D-BB41-BD7A-BDAB5E9919E2}"/>
              </a:ext>
            </a:extLst>
          </p:cNvPr>
          <p:cNvSpPr txBox="1"/>
          <p:nvPr/>
        </p:nvSpPr>
        <p:spPr>
          <a:xfrm>
            <a:off x="1734347" y="3357099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6510E13-2E25-3B49-ABB4-52B19451B0C2}"/>
              </a:ext>
            </a:extLst>
          </p:cNvPr>
          <p:cNvGrpSpPr/>
          <p:nvPr/>
        </p:nvGrpSpPr>
        <p:grpSpPr>
          <a:xfrm>
            <a:off x="4517847" y="3129722"/>
            <a:ext cx="2754058" cy="2065543"/>
            <a:chOff x="4386892" y="4814816"/>
            <a:chExt cx="2538798" cy="1904098"/>
          </a:xfrm>
        </p:grpSpPr>
        <p:pic>
          <p:nvPicPr>
            <p:cNvPr id="105" name="図 104">
              <a:extLst>
                <a:ext uri="{FF2B5EF4-FFF2-40B4-BE49-F238E27FC236}">
                  <a16:creationId xmlns:a16="http://schemas.microsoft.com/office/drawing/2014/main" id="{CDDD10EE-5A4C-B44F-AE4A-408EB774B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386892" y="4814816"/>
              <a:ext cx="2538798" cy="1904098"/>
            </a:xfrm>
            <a:prstGeom prst="rect">
              <a:avLst/>
            </a:prstGeom>
          </p:spPr>
        </p:pic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9EF1011A-1765-9B42-82ED-4B5197BA29FB}"/>
                </a:ext>
              </a:extLst>
            </p:cNvPr>
            <p:cNvCxnSpPr/>
            <p:nvPr/>
          </p:nvCxnSpPr>
          <p:spPr>
            <a:xfrm>
              <a:off x="4486199" y="6635018"/>
              <a:ext cx="597118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7566D28-AFC7-8A47-A1C7-81FF461B119D}"/>
              </a:ext>
            </a:extLst>
          </p:cNvPr>
          <p:cNvSpPr txBox="1"/>
          <p:nvPr/>
        </p:nvSpPr>
        <p:spPr>
          <a:xfrm>
            <a:off x="4453951" y="3097022"/>
            <a:ext cx="3802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>
                <a:latin typeface="Arial"/>
                <a:cs typeface="Arial"/>
              </a:rPr>
              <a:t>(D)</a:t>
            </a:r>
            <a:endParaRPr kumimoji="1" lang="ja-JP" altLang="en-US" sz="1100" b="1" dirty="0">
              <a:latin typeface="Arial"/>
              <a:cs typeface="Arial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3EF9A641-224A-0640-A546-EEC3F3732FA2}"/>
              </a:ext>
            </a:extLst>
          </p:cNvPr>
          <p:cNvSpPr txBox="1"/>
          <p:nvPr/>
        </p:nvSpPr>
        <p:spPr>
          <a:xfrm>
            <a:off x="5526638" y="3836145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56D1305-B32F-584C-BF23-7571EBB83E94}"/>
              </a:ext>
            </a:extLst>
          </p:cNvPr>
          <p:cNvSpPr txBox="1"/>
          <p:nvPr/>
        </p:nvSpPr>
        <p:spPr>
          <a:xfrm>
            <a:off x="6595331" y="3497869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F06E824-2863-6A43-A397-7EC3BB728F9C}"/>
              </a:ext>
            </a:extLst>
          </p:cNvPr>
          <p:cNvSpPr txBox="1"/>
          <p:nvPr/>
        </p:nvSpPr>
        <p:spPr>
          <a:xfrm>
            <a:off x="6657465" y="474762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A5F2424B-7D47-C748-9FBC-DAA1E199922E}"/>
              </a:ext>
            </a:extLst>
          </p:cNvPr>
          <p:cNvSpPr txBox="1"/>
          <p:nvPr/>
        </p:nvSpPr>
        <p:spPr>
          <a:xfrm>
            <a:off x="5757604" y="4887488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6C2DF72A-8B78-E146-868E-813515B1C924}"/>
              </a:ext>
            </a:extLst>
          </p:cNvPr>
          <p:cNvSpPr txBox="1"/>
          <p:nvPr/>
        </p:nvSpPr>
        <p:spPr>
          <a:xfrm>
            <a:off x="4835167" y="3221721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92793733-1625-F64C-9F74-72D216A0EE2D}"/>
              </a:ext>
            </a:extLst>
          </p:cNvPr>
          <p:cNvSpPr txBox="1"/>
          <p:nvPr/>
        </p:nvSpPr>
        <p:spPr>
          <a:xfrm>
            <a:off x="7086745" y="4008604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*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7" name="円/楕円 36">
            <a:extLst>
              <a:ext uri="{FF2B5EF4-FFF2-40B4-BE49-F238E27FC236}">
                <a16:creationId xmlns:a16="http://schemas.microsoft.com/office/drawing/2014/main" id="{D3C4A58A-CE98-464E-BC91-92B3DD14A090}"/>
              </a:ext>
            </a:extLst>
          </p:cNvPr>
          <p:cNvSpPr/>
          <p:nvPr/>
        </p:nvSpPr>
        <p:spPr>
          <a:xfrm>
            <a:off x="3414686" y="2174135"/>
            <a:ext cx="828092" cy="828092"/>
          </a:xfrm>
          <a:prstGeom prst="ellipse">
            <a:avLst/>
          </a:prstGeom>
          <a:noFill/>
          <a:ln w="12700">
            <a:solidFill>
              <a:srgbClr val="FFFF00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838023F-AEA3-3A43-ACAF-18C1F0C8D14A}"/>
              </a:ext>
            </a:extLst>
          </p:cNvPr>
          <p:cNvSpPr/>
          <p:nvPr/>
        </p:nvSpPr>
        <p:spPr>
          <a:xfrm>
            <a:off x="1315634" y="5562223"/>
            <a:ext cx="6632612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Supplementary Fig. S7 Multiple renal cyst formation in neonatal </a:t>
            </a:r>
            <a:r>
              <a:rPr lang="en-US" altLang="ja-JP" sz="1100" b="1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b="1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2 pig at 3 days of age.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A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The gross morphology of the kidney in </a:t>
            </a:r>
            <a:r>
              <a:rPr lang="en-US" altLang="ja-JP" sz="11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PKD1</a:t>
            </a:r>
            <a:r>
              <a:rPr lang="en-US" altLang="ja-JP" sz="1100" i="1" kern="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insG/+ 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F2 progeny (#1730-1). Dotted circle indicates multiple renal cysts. The bar is 1 cm.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B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Sections of hematoxylin-eosin staining of the kidney with numerous cysts. The bar is 5 mm. Sections of Masson’s trichrome staining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C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 and immunostaining using PKD1 antibody (</a:t>
            </a:r>
            <a:r>
              <a:rPr lang="en-US" altLang="ja-JP" sz="1100" b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D</a:t>
            </a:r>
            <a:r>
              <a:rPr lang="en-US" altLang="ja-JP" sz="1100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</a:rPr>
              <a:t>). Asterisks indicate renal cysts. The bars are 500 µm.</a:t>
            </a:r>
            <a:endParaRPr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12583545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E2EA573-C7E1-DD41-BD98-B8FA5B2DDE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7696384"/>
              </p:ext>
            </p:extLst>
          </p:nvPr>
        </p:nvGraphicFramePr>
        <p:xfrm>
          <a:off x="698987" y="1432193"/>
          <a:ext cx="7886701" cy="3693802"/>
        </p:xfrm>
        <a:graphic>
          <a:graphicData uri="http://schemas.openxmlformats.org/drawingml/2006/table">
            <a:tbl>
              <a:tblPr firstRow="1" firstCol="1" bandRow="1"/>
              <a:tblGrid>
                <a:gridCol w="1040606">
                  <a:extLst>
                    <a:ext uri="{9D8B030D-6E8A-4147-A177-3AD203B41FA5}">
                      <a16:colId xmlns:a16="http://schemas.microsoft.com/office/drawing/2014/main" val="3366712372"/>
                    </a:ext>
                  </a:extLst>
                </a:gridCol>
                <a:gridCol w="2146935">
                  <a:extLst>
                    <a:ext uri="{9D8B030D-6E8A-4147-A177-3AD203B41FA5}">
                      <a16:colId xmlns:a16="http://schemas.microsoft.com/office/drawing/2014/main" val="1936129901"/>
                    </a:ext>
                  </a:extLst>
                </a:gridCol>
                <a:gridCol w="690086">
                  <a:extLst>
                    <a:ext uri="{9D8B030D-6E8A-4147-A177-3AD203B41FA5}">
                      <a16:colId xmlns:a16="http://schemas.microsoft.com/office/drawing/2014/main" val="2089437040"/>
                    </a:ext>
                  </a:extLst>
                </a:gridCol>
                <a:gridCol w="1292543">
                  <a:extLst>
                    <a:ext uri="{9D8B030D-6E8A-4147-A177-3AD203B41FA5}">
                      <a16:colId xmlns:a16="http://schemas.microsoft.com/office/drawing/2014/main" val="912209500"/>
                    </a:ext>
                  </a:extLst>
                </a:gridCol>
                <a:gridCol w="657225">
                  <a:extLst>
                    <a:ext uri="{9D8B030D-6E8A-4147-A177-3AD203B41FA5}">
                      <a16:colId xmlns:a16="http://schemas.microsoft.com/office/drawing/2014/main" val="2892380743"/>
                    </a:ext>
                  </a:extLst>
                </a:gridCol>
                <a:gridCol w="1029653">
                  <a:extLst>
                    <a:ext uri="{9D8B030D-6E8A-4147-A177-3AD203B41FA5}">
                      <a16:colId xmlns:a16="http://schemas.microsoft.com/office/drawing/2014/main" val="560498396"/>
                    </a:ext>
                  </a:extLst>
                </a:gridCol>
                <a:gridCol w="1029653">
                  <a:extLst>
                    <a:ext uri="{9D8B030D-6E8A-4147-A177-3AD203B41FA5}">
                      <a16:colId xmlns:a16="http://schemas.microsoft.com/office/drawing/2014/main" val="3097263631"/>
                    </a:ext>
                  </a:extLst>
                </a:gridCol>
              </a:tblGrid>
              <a:tr h="240983">
                <a:tc gridSpan="6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upplementary Table S1. 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ist of off-target candidate sites for the </a:t>
                      </a: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</a:t>
                      </a: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targeted CRISPR-Cas9.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0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Yu Gothic" panose="020B0400000000000000" pitchFamily="34" charset="-128"/>
                          <a:cs typeface="ＭＳ Ｐゴシック" panose="020B0600070205080204" pitchFamily="34" charset="-128"/>
                        </a:rPr>
                        <a:t>　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160313"/>
                  </a:ext>
                </a:extLst>
              </a:tr>
              <a:tr h="31546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ocus name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equence*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core**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oordinate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trand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enomic region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utation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51185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On-target   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CTGCCGCGTCA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-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3:42331574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Exon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ne</a:t>
                      </a:r>
                      <a:r>
                        <a:rPr lang="ja-JP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9663780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1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gCTGCCtCGcCA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5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1:106639405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4291242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2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CctCCaCcTCA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3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15:40226642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2056191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3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gTGCCcCGTgAACTGCTCCA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7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3:5484736  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840499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4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CTGCaGtGTCA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3:114783275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7916791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5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CTtCgGgGTCAACTGCTCCA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3:125537809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192153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6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aTcCCaCGTCcACTGCTCTA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X:6353764  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071274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7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CgGCtGCtgCA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5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2:157646763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2329946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8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CTGCtGCGgCcACTGCTCTA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4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9:13560201 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7362774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9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CTGCCctGTCcACTGCTC</a:t>
                      </a:r>
                      <a:r>
                        <a:rPr lang="en-US" sz="1000" u="sng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4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4:84474106 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1350257"/>
                  </a:ext>
                </a:extLst>
              </a:tr>
              <a:tr h="2409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10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CCaGCCGCagCAACTGCTtCAG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3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hrX:121475252  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+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ntergenic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t detected</a:t>
                      </a:r>
                      <a:endParaRPr lang="ja-JP" sz="10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6560686"/>
                  </a:ext>
                </a:extLst>
              </a:tr>
              <a:tr h="240983">
                <a:tc gridSpan="7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* Lowercase letters indicate mismatches. PAM sequences are underlined.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964657"/>
                  </a:ext>
                </a:extLst>
              </a:tr>
              <a:tr h="240983">
                <a:tc gridSpan="7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** Scores were calculated by the CRISPR design tool (http://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rispr.mit.edu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/). 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4221" marR="5422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78737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410058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454D61D8-9DB4-F040-BCC7-9E0967DFE6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1140904"/>
              </p:ext>
            </p:extLst>
          </p:nvPr>
        </p:nvGraphicFramePr>
        <p:xfrm>
          <a:off x="656786" y="1528071"/>
          <a:ext cx="7886700" cy="3173916"/>
        </p:xfrm>
        <a:graphic>
          <a:graphicData uri="http://schemas.openxmlformats.org/drawingml/2006/table">
            <a:tbl>
              <a:tblPr firstRow="1" firstCol="1" bandRow="1"/>
              <a:tblGrid>
                <a:gridCol w="1358532">
                  <a:extLst>
                    <a:ext uri="{9D8B030D-6E8A-4147-A177-3AD203B41FA5}">
                      <a16:colId xmlns:a16="http://schemas.microsoft.com/office/drawing/2014/main" val="281192343"/>
                    </a:ext>
                  </a:extLst>
                </a:gridCol>
                <a:gridCol w="2176056">
                  <a:extLst>
                    <a:ext uri="{9D8B030D-6E8A-4147-A177-3AD203B41FA5}">
                      <a16:colId xmlns:a16="http://schemas.microsoft.com/office/drawing/2014/main" val="2488412587"/>
                    </a:ext>
                  </a:extLst>
                </a:gridCol>
                <a:gridCol w="2176056">
                  <a:extLst>
                    <a:ext uri="{9D8B030D-6E8A-4147-A177-3AD203B41FA5}">
                      <a16:colId xmlns:a16="http://schemas.microsoft.com/office/drawing/2014/main" val="1816985901"/>
                    </a:ext>
                  </a:extLst>
                </a:gridCol>
                <a:gridCol w="2176056">
                  <a:extLst>
                    <a:ext uri="{9D8B030D-6E8A-4147-A177-3AD203B41FA5}">
                      <a16:colId xmlns:a16="http://schemas.microsoft.com/office/drawing/2014/main" val="4068577528"/>
                    </a:ext>
                  </a:extLst>
                </a:gridCol>
              </a:tblGrid>
              <a:tr h="264493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rimer sequences for off-target analysis</a:t>
                      </a:r>
                      <a:endParaRPr lang="ja-JP" sz="105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Yu Gothic" panose="020B0400000000000000" pitchFamily="34" charset="-128"/>
                          <a:cs typeface="ＭＳ Ｐゴシック" panose="020B0600070205080204" pitchFamily="34" charset="-128"/>
                        </a:rPr>
                        <a:t>　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ja-JP" sz="1100" kern="0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Yu Gothic" panose="020B0400000000000000" pitchFamily="34" charset="-128"/>
                          <a:cs typeface="ＭＳ Ｐゴシック" panose="020B0600070205080204" pitchFamily="34" charset="-128"/>
                        </a:rPr>
                        <a:t>　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027504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ocus name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orward primer (5'-&gt;3'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verse primer (5'-&gt;3'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equence primer (5'-&gt;3')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3945292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1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ACCGAGAAGAAATGAATGC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CATGGGAGAGTTACGAG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CACTGAGTCAGAGAGGTTG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0667017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2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TAGGTGTGCTGCAGGCCTA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TGGCTGAGGCACTGAGGAT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GTCCATCACTGTCAATTGGT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004772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3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AGAGGGCCAGCGACAGCTG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GCACAGAGGACCTGGCT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CTGTCTCATCTGGAGCACG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2604215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4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AGGTGAGAGTAACATGCAGT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TGGTTGAAGTGTGTCAGGTC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AAGCCACTGCACACTGTA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965836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5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AAGCTCCAAGCTCAGGCCT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ACGTGCAGTGGCCCTGCT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TGGAGAGCTGTTAACTGAG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4139437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6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AGCTGCACCCTCAGCATATG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AGATGGCACTGCAGCGATC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AGGTCGAGGCCAGGGAAC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613544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7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AGCGCTCTCAGTAAACGGCA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GTGGCTGAAGAGCAGGGCA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AGATCACCCAGCAGAG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0743489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8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TGTGTTGGCACCGACAA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TAGCTCACAGCAACACCGGAT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GAGCTGTTCACTCTGGTTCT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8041567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9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ACTGTGCCTGGACCCCGTG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GTACATCCGCTATGGGTTCTG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CTGCCTGGCTGTAGTCCCCT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1837494"/>
                  </a:ext>
                </a:extLst>
              </a:tr>
              <a:tr h="26449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KD1-OTS10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TTCTGGGGTCTGGCAGGCAC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TAATCTGCAGACTGACCCCT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TCAGTCAATGGTCTATGGTAG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59511" marR="5951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479169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87C4E71B-BA5D-FB46-AE5B-488E9337C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446" y="1251072"/>
            <a:ext cx="29184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Table S1 (Continued).</a:t>
            </a:r>
            <a:endParaRPr kumimoji="0" lang="ja-JP" altLang="ja-JP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555686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65</TotalTime>
  <Words>1514</Words>
  <Application>Microsoft Macintosh PowerPoint</Application>
  <PresentationFormat>画面に合わせる (4:3)</PresentationFormat>
  <Paragraphs>367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27" baseType="lpstr">
      <vt:lpstr>Klee Demibold</vt:lpstr>
      <vt:lpstr>ＭＳ Ｐゴシック</vt:lpstr>
      <vt:lpstr>MS Mincho</vt:lpstr>
      <vt:lpstr>MS Mincho</vt:lpstr>
      <vt:lpstr>Yu Gothic</vt:lpstr>
      <vt:lpstr>Yu Gothic</vt:lpstr>
      <vt:lpstr>游ゴシック Light</vt:lpstr>
      <vt:lpstr>游明朝</vt:lpstr>
      <vt:lpstr>Apple Color Emoji</vt:lpstr>
      <vt:lpstr>Arial</vt:lpstr>
      <vt:lpstr>Calibri</vt:lpstr>
      <vt:lpstr>Calibri Light</vt:lpstr>
      <vt:lpstr>Courier New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邊</dc:creator>
  <cp:lastModifiedBy>渡邊</cp:lastModifiedBy>
  <cp:revision>122</cp:revision>
  <cp:lastPrinted>2021-11-12T08:08:11Z</cp:lastPrinted>
  <dcterms:created xsi:type="dcterms:W3CDTF">2021-03-22T09:39:11Z</dcterms:created>
  <dcterms:modified xsi:type="dcterms:W3CDTF">2021-11-16T01:52:44Z</dcterms:modified>
</cp:coreProperties>
</file>